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0" r:id="rId2"/>
    <p:sldId id="308" r:id="rId3"/>
  </p:sldIdLst>
  <p:sldSz cx="7772400" cy="10058400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63" d="100"/>
          <a:sy n="63" d="100"/>
        </p:scale>
        <p:origin x="23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70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564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629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957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80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1179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795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928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118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36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820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F73C0-D231-400D-8304-70E96B338032}" type="datetimeFigureOut">
              <a:rPr lang="en-US" smtClean="0"/>
              <a:t>2/2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33678-7FB8-4040-A06B-DE44C9FC52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9009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248782F-D8FC-5AA5-4BE6-293C707F3529}"/>
              </a:ext>
            </a:extLst>
          </p:cNvPr>
          <p:cNvSpPr txBox="1"/>
          <p:nvPr/>
        </p:nvSpPr>
        <p:spPr>
          <a:xfrm>
            <a:off x="916686" y="4996934"/>
            <a:ext cx="5939028" cy="1354217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effectLst/>
                <a:latin typeface="MinionPro-Bold"/>
                <a:ea typeface="Calibri" panose="020F0502020204030204" pitchFamily="34" charset="0"/>
                <a:cs typeface="MinionPro-Bold"/>
              </a:rPr>
              <a:t>S6 Fig. Q1mcp qPCR assay efficiency. 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The assay was run without </a:t>
            </a:r>
            <a:r>
              <a:rPr lang="en-CA" sz="1000" b="1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 or with </a:t>
            </a:r>
            <a:r>
              <a:rPr lang="en-CA" sz="1000" b="1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 the APC probe.  </a:t>
            </a:r>
            <a:r>
              <a:rPr lang="en-CA" sz="1000" b="1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DNA templates were prepared from inoculated Lake Sturgeon gonad cell monolayers (AciHV-3 DNA positive cell lysate), virus DNA -positive Lake Sturgeon fin tissue (</a:t>
            </a:r>
            <a:r>
              <a:rPr lang="en-CA" sz="1000" kern="120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AciHV-3 DNA positive 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tissue) or plasmid DNA encoding the AciHV-3 major capsid protein (</a:t>
            </a:r>
            <a:r>
              <a:rPr lang="en-CA" sz="1000" kern="1200" dirty="0" err="1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mcp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) (pAciHV-3-mcp). The relative performance of the duplex assay presented in </a:t>
            </a:r>
            <a:r>
              <a:rPr lang="en-CA" sz="1000" b="1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 was evaluated with plasmid DNA from the artificial positive control construct (APC) (pLSAciHV3-APC).  Cycle threshold (Ct) values for the fluorescently-labelled probes were generated with 5 or 10-fold serially diluted nucleic acid.  Standard curves were generated using linear regression.  AciHV-3, </a:t>
            </a:r>
            <a:r>
              <a:rPr lang="en-CA" sz="1000" dirty="0" err="1">
                <a:solidFill>
                  <a:srgbClr val="000000"/>
                </a:solidFill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CA" sz="1000" kern="1200" dirty="0" err="1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cipenserid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 herpesvirus 3; </a:t>
            </a:r>
            <a:r>
              <a:rPr lang="en-CA" sz="1000" kern="1200" dirty="0" err="1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dRn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, ROX-normalized</a:t>
            </a:r>
            <a:r>
              <a:rPr lang="en-US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, baseline corrected fluorescence view</a:t>
            </a:r>
            <a:r>
              <a:rPr lang="en-CA" sz="100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CA" sz="850" kern="1200" dirty="0">
                <a:solidFill>
                  <a:srgbClr val="000000"/>
                </a:solidFill>
                <a:effectLst/>
                <a:latin typeface="MinionPro-Regular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7B1721-7C23-BA43-0D01-97AD99A4CC49}"/>
              </a:ext>
            </a:extLst>
          </p:cNvPr>
          <p:cNvSpPr txBox="1"/>
          <p:nvPr/>
        </p:nvSpPr>
        <p:spPr>
          <a:xfrm>
            <a:off x="916686" y="6426998"/>
            <a:ext cx="593902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Any use of trade, firm, or product names is for descriptive purposes only and does not imply endorsement by the U.S. Government.</a:t>
            </a:r>
            <a:r>
              <a:rPr lang="en-US" sz="800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DFA38C4-DDEF-9BE4-A4B2-67E45109C7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9112" y="1917087"/>
            <a:ext cx="6734175" cy="2981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227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TextBox 186">
            <a:extLst>
              <a:ext uri="{FF2B5EF4-FFF2-40B4-BE49-F238E27FC236}">
                <a16:creationId xmlns:a16="http://schemas.microsoft.com/office/drawing/2014/main" id="{0B8B403D-7C36-46A4-BE54-4C374123AC4D}"/>
              </a:ext>
            </a:extLst>
          </p:cNvPr>
          <p:cNvSpPr txBox="1"/>
          <p:nvPr/>
        </p:nvSpPr>
        <p:spPr>
          <a:xfrm>
            <a:off x="373280" y="6761702"/>
            <a:ext cx="7025841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sz="850" b="1" dirty="0"/>
              <a:t>S6 Fig. Q1mcp qPCR assay efficiency. </a:t>
            </a:r>
            <a:r>
              <a:rPr lang="en-CA" sz="850" dirty="0"/>
              <a:t>The assay was run without </a:t>
            </a:r>
            <a:r>
              <a:rPr lang="en-CA" sz="850" b="1" dirty="0"/>
              <a:t>(A)</a:t>
            </a:r>
            <a:r>
              <a:rPr lang="en-CA" sz="850" dirty="0"/>
              <a:t> or with </a:t>
            </a:r>
            <a:r>
              <a:rPr lang="en-CA" sz="850" b="1" dirty="0"/>
              <a:t>(B)</a:t>
            </a:r>
            <a:r>
              <a:rPr lang="en-CA" sz="850" dirty="0"/>
              <a:t> the APC probe.  </a:t>
            </a:r>
            <a:r>
              <a:rPr lang="en-CA" sz="850" b="1" dirty="0"/>
              <a:t>(A) </a:t>
            </a:r>
            <a:r>
              <a:rPr lang="en-CA" sz="850" dirty="0"/>
              <a:t>DNA templates were prepared from inoculated Lake Sturgeon gonad cell monolayers (AciHV-3 DNA positive cell lysate), virus DNA-positive Lake Sturgeon fin tissue (AciHV-3 DNA positive tissue) or plasmid DNA encoding the AciHV-3 major capsid protein (</a:t>
            </a:r>
            <a:r>
              <a:rPr lang="en-CA" sz="850" dirty="0" err="1"/>
              <a:t>mcp</a:t>
            </a:r>
            <a:r>
              <a:rPr lang="en-CA" sz="850" dirty="0"/>
              <a:t>) (pAciHV-3-mcp). The relative performance of the duplex assay presented in </a:t>
            </a:r>
            <a:r>
              <a:rPr lang="en-CA" sz="850" b="1" dirty="0"/>
              <a:t>(B)</a:t>
            </a:r>
            <a:r>
              <a:rPr lang="en-CA" sz="850" dirty="0"/>
              <a:t> was evaluated with plasmid DNA from the artificial positive control construct (APC) (pLSAciHV3-APC).  Cycle threshold (Ct) values for the fluorescently-labelled probes were generated with 5 or 10-fold serially diluted nucleic acid.  Standard curves were generated using linear regression.  AciHV-3, </a:t>
            </a:r>
            <a:r>
              <a:rPr lang="en-CA" sz="850" dirty="0" err="1"/>
              <a:t>acipenserid</a:t>
            </a:r>
            <a:r>
              <a:rPr lang="en-CA" sz="850" dirty="0"/>
              <a:t> herpesvirus 3; </a:t>
            </a:r>
            <a:r>
              <a:rPr lang="en-CA" sz="850" dirty="0" err="1"/>
              <a:t>dRn</a:t>
            </a:r>
            <a:r>
              <a:rPr lang="en-CA" sz="850" dirty="0"/>
              <a:t>, ROX-normalized</a:t>
            </a:r>
            <a:r>
              <a:rPr lang="en-US" sz="850" dirty="0"/>
              <a:t>, baseline corrected fluorescence view</a:t>
            </a:r>
            <a:r>
              <a:rPr lang="en-CA" sz="850" dirty="0"/>
              <a:t>.  </a:t>
            </a:r>
          </a:p>
        </p:txBody>
      </p:sp>
      <p:grpSp>
        <p:nvGrpSpPr>
          <p:cNvPr id="202" name="Group 201">
            <a:extLst>
              <a:ext uri="{FF2B5EF4-FFF2-40B4-BE49-F238E27FC236}">
                <a16:creationId xmlns:a16="http://schemas.microsoft.com/office/drawing/2014/main" id="{2F263116-A41D-44AB-B30E-E76AC538DEB7}"/>
              </a:ext>
            </a:extLst>
          </p:cNvPr>
          <p:cNvGrpSpPr/>
          <p:nvPr/>
        </p:nvGrpSpPr>
        <p:grpSpPr>
          <a:xfrm>
            <a:off x="4049066" y="3751089"/>
            <a:ext cx="2170925" cy="223139"/>
            <a:chOff x="5729189" y="1952946"/>
            <a:chExt cx="2554029" cy="262516"/>
          </a:xfrm>
        </p:grpSpPr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7A6359A5-DF0D-4D72-BAD9-9FB74A9EA422}"/>
                </a:ext>
              </a:extLst>
            </p:cNvPr>
            <p:cNvGrpSpPr/>
            <p:nvPr/>
          </p:nvGrpSpPr>
          <p:grpSpPr>
            <a:xfrm>
              <a:off x="5729189" y="1952946"/>
              <a:ext cx="288032" cy="262516"/>
              <a:chOff x="1305787" y="1764818"/>
              <a:chExt cx="288032" cy="262516"/>
            </a:xfrm>
          </p:grpSpPr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id="{87B794EA-4186-4992-AC6C-E66A134F2E25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A887E4C3-D94A-4552-9D3D-E599E2D285F6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1</a:t>
                </a:r>
                <a:endParaRPr lang="en-CA" sz="850" baseline="30000" dirty="0"/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877F1546-0E95-466D-B27F-B8759B60C3D7}"/>
                </a:ext>
              </a:extLst>
            </p:cNvPr>
            <p:cNvGrpSpPr/>
            <p:nvPr/>
          </p:nvGrpSpPr>
          <p:grpSpPr>
            <a:xfrm>
              <a:off x="6054442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18" name="Straight Connector 117">
                <a:extLst>
                  <a:ext uri="{FF2B5EF4-FFF2-40B4-BE49-F238E27FC236}">
                    <a16:creationId xmlns:a16="http://schemas.microsoft.com/office/drawing/2014/main" id="{9A9844D2-AE77-4766-8FDE-3149260CF642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9A1CB461-87B3-4CC4-9D68-6E96446A037B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2</a:t>
                </a:r>
                <a:endParaRPr lang="en-CA" sz="850" baseline="30000" dirty="0"/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977712F2-10EC-478E-ADB9-2DE9CCD37505}"/>
                </a:ext>
              </a:extLst>
            </p:cNvPr>
            <p:cNvGrpSpPr/>
            <p:nvPr/>
          </p:nvGrpSpPr>
          <p:grpSpPr>
            <a:xfrm>
              <a:off x="6373690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16" name="Straight Connector 115">
                <a:extLst>
                  <a:ext uri="{FF2B5EF4-FFF2-40B4-BE49-F238E27FC236}">
                    <a16:creationId xmlns:a16="http://schemas.microsoft.com/office/drawing/2014/main" id="{678265C6-760E-4A5F-A3EE-63F4A7C3A224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977BD0B7-54E1-4E86-BCE6-384D23089AD4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3</a:t>
                </a:r>
                <a:endParaRPr lang="en-CA" sz="850" baseline="30000" dirty="0"/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AE259680-7F24-4A82-8C06-3CBC587F31C5}"/>
                </a:ext>
              </a:extLst>
            </p:cNvPr>
            <p:cNvGrpSpPr/>
            <p:nvPr/>
          </p:nvGrpSpPr>
          <p:grpSpPr>
            <a:xfrm>
              <a:off x="6702040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14" name="Straight Connector 113">
                <a:extLst>
                  <a:ext uri="{FF2B5EF4-FFF2-40B4-BE49-F238E27FC236}">
                    <a16:creationId xmlns:a16="http://schemas.microsoft.com/office/drawing/2014/main" id="{3D600CDA-07B4-482A-A464-F57B00B71AB8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47638ADE-F21A-402D-918B-F91C6F3AEDC9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4</a:t>
                </a:r>
                <a:endParaRPr lang="en-CA" sz="850" baseline="30000" dirty="0"/>
              </a:p>
            </p:txBody>
          </p:sp>
        </p:grp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5523954B-D7B0-4310-A9E6-A6F21EDFA3ED}"/>
                </a:ext>
              </a:extLst>
            </p:cNvPr>
            <p:cNvGrpSpPr/>
            <p:nvPr/>
          </p:nvGrpSpPr>
          <p:grpSpPr>
            <a:xfrm>
              <a:off x="7025415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12" name="Straight Connector 111">
                <a:extLst>
                  <a:ext uri="{FF2B5EF4-FFF2-40B4-BE49-F238E27FC236}">
                    <a16:creationId xmlns:a16="http://schemas.microsoft.com/office/drawing/2014/main" id="{9F7E6503-E1B4-4F8E-9F8E-84BB1C1C2C8D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01FF7C9C-641E-4535-9390-C758914A613F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5</a:t>
                </a:r>
                <a:endParaRPr lang="en-CA" sz="850" baseline="30000" dirty="0"/>
              </a:p>
            </p:txBody>
          </p: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E7A9D322-3937-48D3-82B3-F1B30D5078CB}"/>
                </a:ext>
              </a:extLst>
            </p:cNvPr>
            <p:cNvGrpSpPr/>
            <p:nvPr/>
          </p:nvGrpSpPr>
          <p:grpSpPr>
            <a:xfrm>
              <a:off x="7348718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37AB26BD-7DB5-413C-86E2-07BC97B367EB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F1F17C9C-D6CD-437C-8332-E8F1C69AC857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6</a:t>
                </a:r>
                <a:endParaRPr lang="en-CA" sz="850" baseline="30000" dirty="0"/>
              </a:p>
            </p:txBody>
          </p:sp>
        </p:grp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A3169DFD-D813-436E-8606-01174636A5E8}"/>
                </a:ext>
              </a:extLst>
            </p:cNvPr>
            <p:cNvGrpSpPr/>
            <p:nvPr/>
          </p:nvGrpSpPr>
          <p:grpSpPr>
            <a:xfrm>
              <a:off x="7669000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1D8DA405-0C22-4CE0-BD9C-D9D6FF6FF790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E5305418-221E-46D1-860E-C0A4F0CB887E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7</a:t>
                </a:r>
                <a:endParaRPr lang="en-CA" sz="850" baseline="30000" dirty="0"/>
              </a:p>
            </p:txBody>
          </p: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F77CC9D5-3473-44C0-A44D-9A4653D1E847}"/>
                </a:ext>
              </a:extLst>
            </p:cNvPr>
            <p:cNvGrpSpPr/>
            <p:nvPr/>
          </p:nvGrpSpPr>
          <p:grpSpPr>
            <a:xfrm>
              <a:off x="7995186" y="1952946"/>
              <a:ext cx="288032" cy="262514"/>
              <a:chOff x="1305787" y="1764818"/>
              <a:chExt cx="288032" cy="262514"/>
            </a:xfrm>
          </p:grpSpPr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A70C763E-AD1E-42E3-9639-F04490E5903E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8A0EC106-BC3C-4A5B-AB32-82FB6C49CF54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8</a:t>
                </a:r>
                <a:endParaRPr lang="en-CA" sz="850" baseline="30000" dirty="0"/>
              </a:p>
            </p:txBody>
          </p:sp>
        </p:grpSp>
      </p:grpSp>
      <p:pic>
        <p:nvPicPr>
          <p:cNvPr id="190" name="Picture 189">
            <a:extLst>
              <a:ext uri="{FF2B5EF4-FFF2-40B4-BE49-F238E27FC236}">
                <a16:creationId xmlns:a16="http://schemas.microsoft.com/office/drawing/2014/main" id="{346F9E34-E351-4389-96CF-A0AFDEAD6A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4619" y="2898589"/>
            <a:ext cx="1938087" cy="855038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3" name="Group 202">
            <a:extLst>
              <a:ext uri="{FF2B5EF4-FFF2-40B4-BE49-F238E27FC236}">
                <a16:creationId xmlns:a16="http://schemas.microsoft.com/office/drawing/2014/main" id="{D39CA238-6F96-4EFD-87C1-2345EABB9D7E}"/>
              </a:ext>
            </a:extLst>
          </p:cNvPr>
          <p:cNvGrpSpPr/>
          <p:nvPr/>
        </p:nvGrpSpPr>
        <p:grpSpPr>
          <a:xfrm>
            <a:off x="3912331" y="2806660"/>
            <a:ext cx="302971" cy="1055658"/>
            <a:chOff x="5568324" y="820424"/>
            <a:chExt cx="356436" cy="1241951"/>
          </a:xfrm>
        </p:grpSpPr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B22DA073-FF0A-40E8-8197-3524F5AD06E9}"/>
                </a:ext>
              </a:extLst>
            </p:cNvPr>
            <p:cNvCxnSpPr>
              <a:cxnSpLocks/>
            </p:cNvCxnSpPr>
            <p:nvPr/>
          </p:nvCxnSpPr>
          <p:spPr>
            <a:xfrm>
              <a:off x="5821838" y="941083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id="{036D337D-EC3E-44B6-809B-C286AF9DC49A}"/>
                </a:ext>
              </a:extLst>
            </p:cNvPr>
            <p:cNvCxnSpPr>
              <a:cxnSpLocks/>
            </p:cNvCxnSpPr>
            <p:nvPr/>
          </p:nvCxnSpPr>
          <p:spPr>
            <a:xfrm>
              <a:off x="5821838" y="1186350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44F1D3F1-2F3A-48E8-84CC-D1BCAB57E51C}"/>
                </a:ext>
              </a:extLst>
            </p:cNvPr>
            <p:cNvCxnSpPr>
              <a:cxnSpLocks/>
            </p:cNvCxnSpPr>
            <p:nvPr/>
          </p:nvCxnSpPr>
          <p:spPr>
            <a:xfrm>
              <a:off x="5821838" y="1429237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>
              <a:extLst>
                <a:ext uri="{FF2B5EF4-FFF2-40B4-BE49-F238E27FC236}">
                  <a16:creationId xmlns:a16="http://schemas.microsoft.com/office/drawing/2014/main" id="{039FCD1A-D70E-4D10-AE73-8BCB7B6DE788}"/>
                </a:ext>
              </a:extLst>
            </p:cNvPr>
            <p:cNvCxnSpPr>
              <a:cxnSpLocks/>
            </p:cNvCxnSpPr>
            <p:nvPr/>
          </p:nvCxnSpPr>
          <p:spPr>
            <a:xfrm>
              <a:off x="5821838" y="1676893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Straight Connector 195">
              <a:extLst>
                <a:ext uri="{FF2B5EF4-FFF2-40B4-BE49-F238E27FC236}">
                  <a16:creationId xmlns:a16="http://schemas.microsoft.com/office/drawing/2014/main" id="{92AF9B6E-FF52-461F-B2A8-BE521CFF9F23}"/>
                </a:ext>
              </a:extLst>
            </p:cNvPr>
            <p:cNvCxnSpPr>
              <a:cxnSpLocks/>
            </p:cNvCxnSpPr>
            <p:nvPr/>
          </p:nvCxnSpPr>
          <p:spPr>
            <a:xfrm>
              <a:off x="5821838" y="1922159"/>
              <a:ext cx="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E1631CD3-AFBA-4C1F-9C67-225198B770B2}"/>
                </a:ext>
              </a:extLst>
            </p:cNvPr>
            <p:cNvSpPr txBox="1"/>
            <p:nvPr/>
          </p:nvSpPr>
          <p:spPr>
            <a:xfrm>
              <a:off x="5568325" y="1553091"/>
              <a:ext cx="356435" cy="416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10</a:t>
              </a:r>
              <a:endParaRPr lang="en-CA" sz="850" baseline="30000" dirty="0"/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DF388A42-EB1D-4BF3-B2A0-5A11A08A6816}"/>
                </a:ext>
              </a:extLst>
            </p:cNvPr>
            <p:cNvSpPr txBox="1"/>
            <p:nvPr/>
          </p:nvSpPr>
          <p:spPr>
            <a:xfrm>
              <a:off x="5568325" y="1308856"/>
              <a:ext cx="356435" cy="416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20</a:t>
              </a:r>
              <a:endParaRPr lang="en-CA" sz="850" baseline="30000" dirty="0"/>
            </a:p>
          </p:txBody>
        </p: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1B86F8D5-7C02-472A-B0D9-631B853AC653}"/>
                </a:ext>
              </a:extLst>
            </p:cNvPr>
            <p:cNvSpPr txBox="1"/>
            <p:nvPr/>
          </p:nvSpPr>
          <p:spPr>
            <a:xfrm>
              <a:off x="5568325" y="1065368"/>
              <a:ext cx="356435" cy="416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30</a:t>
              </a:r>
              <a:endParaRPr lang="en-CA" sz="850" baseline="30000" dirty="0"/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318D803C-AF88-4F57-9038-0A6CAF084A27}"/>
                </a:ext>
              </a:extLst>
            </p:cNvPr>
            <p:cNvSpPr txBox="1"/>
            <p:nvPr/>
          </p:nvSpPr>
          <p:spPr>
            <a:xfrm>
              <a:off x="5568324" y="820424"/>
              <a:ext cx="356436" cy="416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40</a:t>
              </a:r>
              <a:endParaRPr lang="en-CA" sz="850" baseline="30000" dirty="0"/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id="{7E3D92B6-91E8-4393-8A4C-6D611435477C}"/>
                </a:ext>
              </a:extLst>
            </p:cNvPr>
            <p:cNvSpPr txBox="1"/>
            <p:nvPr/>
          </p:nvSpPr>
          <p:spPr>
            <a:xfrm>
              <a:off x="5636727" y="1799860"/>
              <a:ext cx="288033" cy="26251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0</a:t>
              </a:r>
              <a:endParaRPr lang="en-CA" sz="850" baseline="30000" dirty="0"/>
            </a:p>
          </p:txBody>
        </p:sp>
      </p:grpSp>
      <p:sp>
        <p:nvSpPr>
          <p:cNvPr id="204" name="TextBox 203">
            <a:extLst>
              <a:ext uri="{FF2B5EF4-FFF2-40B4-BE49-F238E27FC236}">
                <a16:creationId xmlns:a16="http://schemas.microsoft.com/office/drawing/2014/main" id="{8B454080-A46C-4D10-81AC-98BF9CC6AAF9}"/>
              </a:ext>
            </a:extLst>
          </p:cNvPr>
          <p:cNvSpPr txBox="1"/>
          <p:nvPr/>
        </p:nvSpPr>
        <p:spPr>
          <a:xfrm>
            <a:off x="3567151" y="3112968"/>
            <a:ext cx="468486" cy="523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935" dirty="0"/>
              <a:t>Ct</a:t>
            </a:r>
          </a:p>
          <a:p>
            <a:pPr algn="ctr"/>
            <a:r>
              <a:rPr lang="en-CA" sz="935" dirty="0"/>
              <a:t>(</a:t>
            </a:r>
            <a:r>
              <a:rPr lang="en-CA" sz="935" dirty="0" err="1"/>
              <a:t>dRn</a:t>
            </a:r>
            <a:r>
              <a:rPr lang="en-CA" sz="935" dirty="0"/>
              <a:t>)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E8D26ED2-9F65-4FFF-B179-4347044AC54B}"/>
              </a:ext>
            </a:extLst>
          </p:cNvPr>
          <p:cNvSpPr txBox="1"/>
          <p:nvPr/>
        </p:nvSpPr>
        <p:spPr>
          <a:xfrm>
            <a:off x="4734247" y="3881330"/>
            <a:ext cx="796262" cy="23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935" dirty="0"/>
              <a:t>Log copies</a:t>
            </a:r>
            <a:endParaRPr lang="en-CA" sz="935" baseline="30000" dirty="0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4D2F58F1-71E7-4FB8-9896-85A02D802431}"/>
              </a:ext>
            </a:extLst>
          </p:cNvPr>
          <p:cNvSpPr txBox="1"/>
          <p:nvPr/>
        </p:nvSpPr>
        <p:spPr>
          <a:xfrm>
            <a:off x="4799912" y="3018284"/>
            <a:ext cx="1364866" cy="190758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A" sz="765" dirty="0"/>
              <a:t>VIC R</a:t>
            </a:r>
            <a:r>
              <a:rPr lang="en-CA" sz="765" baseline="30000" dirty="0"/>
              <a:t>2</a:t>
            </a:r>
            <a:r>
              <a:rPr lang="en-CA" sz="765" dirty="0"/>
              <a:t> 0.997; Y = -3.4x + 39.20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C3D818B8-DD90-481A-BF47-302A0890EACC}"/>
              </a:ext>
            </a:extLst>
          </p:cNvPr>
          <p:cNvSpPr txBox="1"/>
          <p:nvPr/>
        </p:nvSpPr>
        <p:spPr>
          <a:xfrm>
            <a:off x="4129192" y="3435333"/>
            <a:ext cx="1501353" cy="190758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A" sz="765" dirty="0"/>
              <a:t>FAM R</a:t>
            </a:r>
            <a:r>
              <a:rPr lang="en-CA" sz="765" baseline="30000" dirty="0"/>
              <a:t>2</a:t>
            </a:r>
            <a:r>
              <a:rPr lang="en-CA" sz="765" dirty="0"/>
              <a:t> 0.998; Y = -3.5x + 39.07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46D330CB-8141-4503-B6E1-434F44F7DC27}"/>
              </a:ext>
            </a:extLst>
          </p:cNvPr>
          <p:cNvSpPr txBox="1"/>
          <p:nvPr/>
        </p:nvSpPr>
        <p:spPr>
          <a:xfrm>
            <a:off x="3529887" y="2755149"/>
            <a:ext cx="255198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/>
              <a:t>B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B1F26474-7BEA-4490-ABF8-97AA2D276C07}"/>
              </a:ext>
            </a:extLst>
          </p:cNvPr>
          <p:cNvSpPr txBox="1"/>
          <p:nvPr/>
        </p:nvSpPr>
        <p:spPr>
          <a:xfrm>
            <a:off x="793334" y="4397912"/>
            <a:ext cx="468486" cy="380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935" dirty="0"/>
              <a:t>Ct</a:t>
            </a:r>
          </a:p>
          <a:p>
            <a:pPr algn="ctr"/>
            <a:r>
              <a:rPr lang="en-CA" sz="935" dirty="0"/>
              <a:t>(</a:t>
            </a:r>
            <a:r>
              <a:rPr lang="en-CA" sz="935" dirty="0" err="1"/>
              <a:t>dRn</a:t>
            </a:r>
            <a:r>
              <a:rPr lang="en-CA" sz="935" dirty="0"/>
              <a:t>)</a:t>
            </a:r>
          </a:p>
        </p:txBody>
      </p:sp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607AB5E9-DC48-4C1B-A071-7B2E83A59B04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1" t="13272" r="7240" b="13377"/>
          <a:stretch/>
        </p:blipFill>
        <p:spPr>
          <a:xfrm>
            <a:off x="1477847" y="2899887"/>
            <a:ext cx="1937326" cy="849231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BD7135A2-5A7D-3D27-C636-E667E1C7873F}"/>
              </a:ext>
            </a:extLst>
          </p:cNvPr>
          <p:cNvGrpSpPr/>
          <p:nvPr/>
        </p:nvGrpSpPr>
        <p:grpSpPr>
          <a:xfrm>
            <a:off x="1329027" y="3751100"/>
            <a:ext cx="2201527" cy="353943"/>
            <a:chOff x="1355273" y="3751100"/>
            <a:chExt cx="2201527" cy="353943"/>
          </a:xfrm>
        </p:grpSpPr>
        <p:grpSp>
          <p:nvGrpSpPr>
            <p:cNvPr id="61" name="Group 60">
              <a:extLst>
                <a:ext uri="{FF2B5EF4-FFF2-40B4-BE49-F238E27FC236}">
                  <a16:creationId xmlns:a16="http://schemas.microsoft.com/office/drawing/2014/main" id="{F25384FA-D759-46A0-8E3A-C6BA2AFEB2EE}"/>
                </a:ext>
              </a:extLst>
            </p:cNvPr>
            <p:cNvGrpSpPr/>
            <p:nvPr/>
          </p:nvGrpSpPr>
          <p:grpSpPr>
            <a:xfrm>
              <a:off x="1355273" y="3751100"/>
              <a:ext cx="296241" cy="353943"/>
              <a:chOff x="1275544" y="1764818"/>
              <a:chExt cx="348520" cy="416404"/>
            </a:xfrm>
          </p:grpSpPr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A900627D-9841-43FE-AFC9-B1DD9F5D4DFB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2A7656FA-E739-4D5C-A43F-A242AF5AE0C9}"/>
                  </a:ext>
                </a:extLst>
              </p:cNvPr>
              <p:cNvSpPr txBox="1"/>
              <p:nvPr/>
            </p:nvSpPr>
            <p:spPr>
              <a:xfrm>
                <a:off x="1275544" y="1764818"/>
                <a:ext cx="348520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-3</a:t>
                </a:r>
                <a:endParaRPr lang="en-CA" sz="850" baseline="30000" dirty="0"/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14FA9BF8-36E0-495E-B5B0-FD40E8625131}"/>
                </a:ext>
              </a:extLst>
            </p:cNvPr>
            <p:cNvGrpSpPr/>
            <p:nvPr/>
          </p:nvGrpSpPr>
          <p:grpSpPr>
            <a:xfrm>
              <a:off x="1576541" y="3751100"/>
              <a:ext cx="296241" cy="353943"/>
              <a:chOff x="1275544" y="1764818"/>
              <a:chExt cx="348520" cy="416404"/>
            </a:xfrm>
          </p:grpSpPr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E3CB8C42-9682-42A3-9558-95FBD75F4A9E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5CC3BE04-0A58-4EC9-8988-C4F3F04D5C43}"/>
                  </a:ext>
                </a:extLst>
              </p:cNvPr>
              <p:cNvSpPr txBox="1"/>
              <p:nvPr/>
            </p:nvSpPr>
            <p:spPr>
              <a:xfrm>
                <a:off x="1275544" y="1764818"/>
                <a:ext cx="348520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-2</a:t>
                </a:r>
                <a:endParaRPr lang="en-CA" sz="850" baseline="30000" dirty="0"/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1A096C31-AAD1-43D5-BA38-A03C3903C019}"/>
                </a:ext>
              </a:extLst>
            </p:cNvPr>
            <p:cNvGrpSpPr/>
            <p:nvPr/>
          </p:nvGrpSpPr>
          <p:grpSpPr>
            <a:xfrm>
              <a:off x="1792284" y="3751100"/>
              <a:ext cx="296241" cy="353943"/>
              <a:chOff x="1275544" y="1764818"/>
              <a:chExt cx="348520" cy="416404"/>
            </a:xfrm>
          </p:grpSpPr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46D0E27D-45F3-4EA7-96A5-FD6E2EC44062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3427E18B-86A4-463C-9096-9B2811170DD7}"/>
                  </a:ext>
                </a:extLst>
              </p:cNvPr>
              <p:cNvSpPr txBox="1"/>
              <p:nvPr/>
            </p:nvSpPr>
            <p:spPr>
              <a:xfrm>
                <a:off x="1275544" y="1764818"/>
                <a:ext cx="348520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-1</a:t>
                </a:r>
                <a:endParaRPr lang="en-CA" sz="850" baseline="30000" dirty="0"/>
              </a:p>
            </p:txBody>
          </p:sp>
        </p:grp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A59AD953-D460-419E-BEF3-EAEF864D4D64}"/>
                </a:ext>
              </a:extLst>
            </p:cNvPr>
            <p:cNvGrpSpPr/>
            <p:nvPr/>
          </p:nvGrpSpPr>
          <p:grpSpPr>
            <a:xfrm>
              <a:off x="2028628" y="3751100"/>
              <a:ext cx="244827" cy="223138"/>
              <a:chOff x="1305787" y="1764818"/>
              <a:chExt cx="288032" cy="262516"/>
            </a:xfrm>
          </p:grpSpPr>
          <p:cxnSp>
            <p:nvCxnSpPr>
              <p:cNvPr id="71" name="Straight Connector 70">
                <a:extLst>
                  <a:ext uri="{FF2B5EF4-FFF2-40B4-BE49-F238E27FC236}">
                    <a16:creationId xmlns:a16="http://schemas.microsoft.com/office/drawing/2014/main" id="{A221FAAB-9689-40E0-8251-AE902B1A9B26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D7A70638-23A1-45C7-B3A2-3801CFDAE85B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0</a:t>
                </a:r>
                <a:endParaRPr lang="en-CA" sz="850" baseline="30000" dirty="0"/>
              </a:p>
            </p:txBody>
          </p:sp>
        </p:grpSp>
        <p:grpSp>
          <p:nvGrpSpPr>
            <p:cNvPr id="73" name="Group 72">
              <a:extLst>
                <a:ext uri="{FF2B5EF4-FFF2-40B4-BE49-F238E27FC236}">
                  <a16:creationId xmlns:a16="http://schemas.microsoft.com/office/drawing/2014/main" id="{6C6E8069-F0AE-4D83-858B-049BDF3FD922}"/>
                </a:ext>
              </a:extLst>
            </p:cNvPr>
            <p:cNvGrpSpPr/>
            <p:nvPr/>
          </p:nvGrpSpPr>
          <p:grpSpPr>
            <a:xfrm>
              <a:off x="2244981" y="3751100"/>
              <a:ext cx="244827" cy="223138"/>
              <a:chOff x="1305787" y="1764818"/>
              <a:chExt cx="288032" cy="262516"/>
            </a:xfrm>
          </p:grpSpPr>
          <p:cxnSp>
            <p:nvCxnSpPr>
              <p:cNvPr id="74" name="Straight Connector 73">
                <a:extLst>
                  <a:ext uri="{FF2B5EF4-FFF2-40B4-BE49-F238E27FC236}">
                    <a16:creationId xmlns:a16="http://schemas.microsoft.com/office/drawing/2014/main" id="{2A437414-41B0-4C6D-B941-DEF787090774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7F16262D-1E09-4650-88AE-B83E5152A3E1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1</a:t>
                </a:r>
                <a:endParaRPr lang="en-CA" sz="850" baseline="30000" dirty="0"/>
              </a:p>
            </p:txBody>
          </p: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916C97A5-7B8F-4D5C-A91A-20FFB39AE024}"/>
                </a:ext>
              </a:extLst>
            </p:cNvPr>
            <p:cNvGrpSpPr/>
            <p:nvPr/>
          </p:nvGrpSpPr>
          <p:grpSpPr>
            <a:xfrm>
              <a:off x="2457105" y="3751100"/>
              <a:ext cx="244827" cy="223138"/>
              <a:chOff x="1305787" y="1764818"/>
              <a:chExt cx="288032" cy="262516"/>
            </a:xfrm>
          </p:grpSpPr>
          <p:cxnSp>
            <p:nvCxnSpPr>
              <p:cNvPr id="77" name="Straight Connector 76">
                <a:extLst>
                  <a:ext uri="{FF2B5EF4-FFF2-40B4-BE49-F238E27FC236}">
                    <a16:creationId xmlns:a16="http://schemas.microsoft.com/office/drawing/2014/main" id="{7EFD010C-CD11-4FC2-BB16-69FF7F9CE22C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F96025F8-DA95-43D0-81C8-890F74188BCF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2</a:t>
                </a:r>
                <a:endParaRPr lang="en-CA" sz="850" baseline="30000" dirty="0"/>
              </a:p>
            </p:txBody>
          </p:sp>
        </p:grpSp>
        <p:grpSp>
          <p:nvGrpSpPr>
            <p:cNvPr id="79" name="Group 78">
              <a:extLst>
                <a:ext uri="{FF2B5EF4-FFF2-40B4-BE49-F238E27FC236}">
                  <a16:creationId xmlns:a16="http://schemas.microsoft.com/office/drawing/2014/main" id="{F3F91B22-76F5-4EC1-B3C4-CC54DFCC5A0D}"/>
                </a:ext>
              </a:extLst>
            </p:cNvPr>
            <p:cNvGrpSpPr/>
            <p:nvPr/>
          </p:nvGrpSpPr>
          <p:grpSpPr>
            <a:xfrm>
              <a:off x="2671194" y="3751100"/>
              <a:ext cx="244827" cy="223138"/>
              <a:chOff x="1305787" y="1764818"/>
              <a:chExt cx="288032" cy="262516"/>
            </a:xfrm>
          </p:grpSpPr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63D9ECAB-CB90-4608-A34B-92E8C06BDABF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A6696DAF-888B-4F6E-90BD-B9D6F36C87AA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3</a:t>
                </a:r>
                <a:endParaRPr lang="en-CA" sz="850" baseline="30000" dirty="0"/>
              </a:p>
            </p:txBody>
          </p: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EBDEF77A-0EEB-4161-8EAC-F324D9A4D4D8}"/>
                </a:ext>
              </a:extLst>
            </p:cNvPr>
            <p:cNvGrpSpPr/>
            <p:nvPr/>
          </p:nvGrpSpPr>
          <p:grpSpPr>
            <a:xfrm>
              <a:off x="2884736" y="3751100"/>
              <a:ext cx="244827" cy="223138"/>
              <a:chOff x="1305787" y="1764818"/>
              <a:chExt cx="288032" cy="262516"/>
            </a:xfrm>
          </p:grpSpPr>
          <p:cxnSp>
            <p:nvCxnSpPr>
              <p:cNvPr id="83" name="Straight Connector 82">
                <a:extLst>
                  <a:ext uri="{FF2B5EF4-FFF2-40B4-BE49-F238E27FC236}">
                    <a16:creationId xmlns:a16="http://schemas.microsoft.com/office/drawing/2014/main" id="{FBB85C06-EDDF-4522-AD21-2E3929647C92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2B6E5EEA-8DF3-49CA-B4D7-6C7C400B4A32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4</a:t>
                </a:r>
                <a:endParaRPr lang="en-CA" sz="850" baseline="30000" dirty="0"/>
              </a:p>
            </p:txBody>
          </p:sp>
        </p:grpSp>
        <p:grpSp>
          <p:nvGrpSpPr>
            <p:cNvPr id="85" name="Group 84">
              <a:extLst>
                <a:ext uri="{FF2B5EF4-FFF2-40B4-BE49-F238E27FC236}">
                  <a16:creationId xmlns:a16="http://schemas.microsoft.com/office/drawing/2014/main" id="{528D540C-C093-4F00-AE56-0FFB34CA1540}"/>
                </a:ext>
              </a:extLst>
            </p:cNvPr>
            <p:cNvGrpSpPr/>
            <p:nvPr/>
          </p:nvGrpSpPr>
          <p:grpSpPr>
            <a:xfrm>
              <a:off x="3099254" y="3751100"/>
              <a:ext cx="244827" cy="223138"/>
              <a:chOff x="1305787" y="1764818"/>
              <a:chExt cx="288032" cy="262516"/>
            </a:xfrm>
          </p:grpSpPr>
          <p:cxnSp>
            <p:nvCxnSpPr>
              <p:cNvPr id="86" name="Straight Connector 85">
                <a:extLst>
                  <a:ext uri="{FF2B5EF4-FFF2-40B4-BE49-F238E27FC236}">
                    <a16:creationId xmlns:a16="http://schemas.microsoft.com/office/drawing/2014/main" id="{B7B96AAC-4909-41B9-A20F-25B087423F6B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CC2FBD86-D949-4BAB-B354-8EE47CF049E9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5</a:t>
                </a:r>
                <a:endParaRPr lang="en-CA" sz="850" baseline="30000" dirty="0"/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77A42772-B848-43EA-A2F1-3E1F97784F9E}"/>
                </a:ext>
              </a:extLst>
            </p:cNvPr>
            <p:cNvGrpSpPr/>
            <p:nvPr/>
          </p:nvGrpSpPr>
          <p:grpSpPr>
            <a:xfrm>
              <a:off x="3311973" y="3751100"/>
              <a:ext cx="244827" cy="223138"/>
              <a:chOff x="1305787" y="1764818"/>
              <a:chExt cx="288032" cy="262516"/>
            </a:xfrm>
          </p:grpSpPr>
          <p:cxnSp>
            <p:nvCxnSpPr>
              <p:cNvPr id="89" name="Straight Connector 88">
                <a:extLst>
                  <a:ext uri="{FF2B5EF4-FFF2-40B4-BE49-F238E27FC236}">
                    <a16:creationId xmlns:a16="http://schemas.microsoft.com/office/drawing/2014/main" id="{0F3F26BF-F30B-4B20-8B97-6D4DBEA653C0}"/>
                  </a:ext>
                </a:extLst>
              </p:cNvPr>
              <p:cNvCxnSpPr/>
              <p:nvPr/>
            </p:nvCxnSpPr>
            <p:spPr>
              <a:xfrm rot="5400000">
                <a:off x="1432091" y="179196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A99B7B9F-7773-4727-848C-AA81AB979BBB}"/>
                  </a:ext>
                </a:extLst>
              </p:cNvPr>
              <p:cNvSpPr txBox="1"/>
              <p:nvPr/>
            </p:nvSpPr>
            <p:spPr>
              <a:xfrm>
                <a:off x="1305787" y="1764818"/>
                <a:ext cx="288032" cy="262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50" dirty="0"/>
                  <a:t>6</a:t>
                </a:r>
                <a:endParaRPr lang="en-CA" sz="850" baseline="30000" dirty="0"/>
              </a:p>
            </p:txBody>
          </p:sp>
        </p:grpSp>
      </p:grpSp>
      <p:sp>
        <p:nvSpPr>
          <p:cNvPr id="130" name="TextBox 129">
            <a:extLst>
              <a:ext uri="{FF2B5EF4-FFF2-40B4-BE49-F238E27FC236}">
                <a16:creationId xmlns:a16="http://schemas.microsoft.com/office/drawing/2014/main" id="{583C65D9-ED96-4794-A738-7E4800A847C8}"/>
              </a:ext>
            </a:extLst>
          </p:cNvPr>
          <p:cNvSpPr txBox="1"/>
          <p:nvPr/>
        </p:nvSpPr>
        <p:spPr>
          <a:xfrm>
            <a:off x="2033310" y="3881330"/>
            <a:ext cx="796262" cy="23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935" dirty="0"/>
              <a:t>Log ng DNA</a:t>
            </a:r>
            <a:endParaRPr lang="en-CA" sz="935" baseline="30000" dirty="0"/>
          </a:p>
        </p:txBody>
      </p: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FF22DA91-3A07-4098-B11E-3494A77E598D}"/>
              </a:ext>
            </a:extLst>
          </p:cNvPr>
          <p:cNvCxnSpPr>
            <a:cxnSpLocks/>
          </p:cNvCxnSpPr>
          <p:nvPr/>
        </p:nvCxnSpPr>
        <p:spPr>
          <a:xfrm>
            <a:off x="1439462" y="2909220"/>
            <a:ext cx="3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A6F9FD0D-3F81-457B-9AEA-6F91A53549D9}"/>
              </a:ext>
            </a:extLst>
          </p:cNvPr>
          <p:cNvCxnSpPr>
            <a:cxnSpLocks/>
          </p:cNvCxnSpPr>
          <p:nvPr/>
        </p:nvCxnSpPr>
        <p:spPr>
          <a:xfrm>
            <a:off x="1439462" y="3115673"/>
            <a:ext cx="3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25E7E5E9-3016-4D05-9A65-C643ABB43743}"/>
              </a:ext>
            </a:extLst>
          </p:cNvPr>
          <p:cNvCxnSpPr>
            <a:cxnSpLocks/>
          </p:cNvCxnSpPr>
          <p:nvPr/>
        </p:nvCxnSpPr>
        <p:spPr>
          <a:xfrm>
            <a:off x="1439462" y="3324151"/>
            <a:ext cx="3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8D7CE609-3BD6-4759-B571-9BDF15735093}"/>
              </a:ext>
            </a:extLst>
          </p:cNvPr>
          <p:cNvCxnSpPr>
            <a:cxnSpLocks/>
          </p:cNvCxnSpPr>
          <p:nvPr/>
        </p:nvCxnSpPr>
        <p:spPr>
          <a:xfrm>
            <a:off x="1439462" y="3532635"/>
            <a:ext cx="3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762CD00E-69F2-4A26-B8FD-DCDEF6DC1A62}"/>
              </a:ext>
            </a:extLst>
          </p:cNvPr>
          <p:cNvCxnSpPr>
            <a:cxnSpLocks/>
          </p:cNvCxnSpPr>
          <p:nvPr/>
        </p:nvCxnSpPr>
        <p:spPr>
          <a:xfrm>
            <a:off x="1439462" y="3739087"/>
            <a:ext cx="306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" name="Group 5">
            <a:extLst>
              <a:ext uri="{FF2B5EF4-FFF2-40B4-BE49-F238E27FC236}">
                <a16:creationId xmlns:a16="http://schemas.microsoft.com/office/drawing/2014/main" id="{7E6A80A3-0CD0-7392-66D4-809BAE27DDDC}"/>
              </a:ext>
            </a:extLst>
          </p:cNvPr>
          <p:cNvGrpSpPr/>
          <p:nvPr/>
        </p:nvGrpSpPr>
        <p:grpSpPr>
          <a:xfrm>
            <a:off x="1223975" y="2806660"/>
            <a:ext cx="302971" cy="1051611"/>
            <a:chOff x="1250221" y="2806660"/>
            <a:chExt cx="302971" cy="1051611"/>
          </a:xfrm>
        </p:grpSpPr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24C28A8E-E376-425E-BC32-CC856ECEE730}"/>
                </a:ext>
              </a:extLst>
            </p:cNvPr>
            <p:cNvSpPr txBox="1"/>
            <p:nvPr/>
          </p:nvSpPr>
          <p:spPr>
            <a:xfrm>
              <a:off x="1250222" y="3427403"/>
              <a:ext cx="302970" cy="3539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10</a:t>
              </a:r>
              <a:endParaRPr lang="en-CA" sz="850" baseline="30000" dirty="0"/>
            </a:p>
          </p:txBody>
        </p:sp>
        <p:sp>
          <p:nvSpPr>
            <p:cNvPr id="153" name="TextBox 152">
              <a:extLst>
                <a:ext uri="{FF2B5EF4-FFF2-40B4-BE49-F238E27FC236}">
                  <a16:creationId xmlns:a16="http://schemas.microsoft.com/office/drawing/2014/main" id="{D0FCA7A5-A1A8-4BBA-B4DD-20E422EA0B53}"/>
                </a:ext>
              </a:extLst>
            </p:cNvPr>
            <p:cNvSpPr txBox="1"/>
            <p:nvPr/>
          </p:nvSpPr>
          <p:spPr>
            <a:xfrm>
              <a:off x="1250222" y="3221827"/>
              <a:ext cx="302970" cy="3539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20</a:t>
              </a:r>
              <a:endParaRPr lang="en-CA" sz="850" baseline="30000" dirty="0"/>
            </a:p>
          </p:txBody>
        </p: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EAD8E3EC-2B51-4133-8C25-691278F660AE}"/>
                </a:ext>
              </a:extLst>
            </p:cNvPr>
            <p:cNvSpPr txBox="1"/>
            <p:nvPr/>
          </p:nvSpPr>
          <p:spPr>
            <a:xfrm>
              <a:off x="1250222" y="3012839"/>
              <a:ext cx="302970" cy="3539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30</a:t>
              </a:r>
              <a:endParaRPr lang="en-CA" sz="850" baseline="30000" dirty="0"/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BB37733F-600F-4CD6-A2C9-54751192AC85}"/>
                </a:ext>
              </a:extLst>
            </p:cNvPr>
            <p:cNvSpPr txBox="1"/>
            <p:nvPr/>
          </p:nvSpPr>
          <p:spPr>
            <a:xfrm>
              <a:off x="1250221" y="2806660"/>
              <a:ext cx="302971" cy="3539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40</a:t>
              </a:r>
              <a:endParaRPr lang="en-CA" sz="850" baseline="30000" dirty="0"/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1B487284-2B99-4D74-B1EC-355962DB6EAC}"/>
                </a:ext>
              </a:extLst>
            </p:cNvPr>
            <p:cNvSpPr txBox="1"/>
            <p:nvPr/>
          </p:nvSpPr>
          <p:spPr>
            <a:xfrm>
              <a:off x="1308365" y="3635133"/>
              <a:ext cx="244827" cy="223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850" dirty="0"/>
                <a:t>0</a:t>
              </a:r>
              <a:endParaRPr lang="en-CA" sz="850" baseline="30000" dirty="0"/>
            </a:p>
          </p:txBody>
        </p:sp>
      </p:grpSp>
      <p:sp>
        <p:nvSpPr>
          <p:cNvPr id="181" name="TextBox 180">
            <a:extLst>
              <a:ext uri="{FF2B5EF4-FFF2-40B4-BE49-F238E27FC236}">
                <a16:creationId xmlns:a16="http://schemas.microsoft.com/office/drawing/2014/main" id="{7AA565EC-92A0-4076-BD21-7B7F51DB4A50}"/>
              </a:ext>
            </a:extLst>
          </p:cNvPr>
          <p:cNvSpPr txBox="1"/>
          <p:nvPr/>
        </p:nvSpPr>
        <p:spPr>
          <a:xfrm>
            <a:off x="2216637" y="2939376"/>
            <a:ext cx="1252145" cy="190758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A" sz="765" dirty="0"/>
              <a:t>R</a:t>
            </a:r>
            <a:r>
              <a:rPr lang="en-CA" sz="765" baseline="30000" dirty="0"/>
              <a:t>2</a:t>
            </a:r>
            <a:r>
              <a:rPr lang="en-CA" sz="765" dirty="0"/>
              <a:t> 0.998; Y = -3.6x + 28.6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464346A1-D19D-4A1A-A05F-CC3FFB911AE4}"/>
              </a:ext>
            </a:extLst>
          </p:cNvPr>
          <p:cNvSpPr txBox="1"/>
          <p:nvPr/>
        </p:nvSpPr>
        <p:spPr>
          <a:xfrm>
            <a:off x="1433938" y="3627847"/>
            <a:ext cx="1516902" cy="96565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A" sz="765" dirty="0"/>
              <a:t>AciHV-3 DNA positive cell lysate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DA92E8CA-839A-5F16-2F19-3F999BDFEC33}"/>
              </a:ext>
            </a:extLst>
          </p:cNvPr>
          <p:cNvGrpSpPr/>
          <p:nvPr/>
        </p:nvGrpSpPr>
        <p:grpSpPr>
          <a:xfrm>
            <a:off x="1223975" y="4064503"/>
            <a:ext cx="2307707" cy="1302502"/>
            <a:chOff x="1249093" y="4064503"/>
            <a:chExt cx="2307707" cy="1302502"/>
          </a:xfrm>
        </p:grpSpPr>
        <p:grpSp>
          <p:nvGrpSpPr>
            <p:cNvPr id="149" name="Group 148">
              <a:extLst>
                <a:ext uri="{FF2B5EF4-FFF2-40B4-BE49-F238E27FC236}">
                  <a16:creationId xmlns:a16="http://schemas.microsoft.com/office/drawing/2014/main" id="{DA7215B5-719B-4435-B98F-C49851D14FA4}"/>
                </a:ext>
              </a:extLst>
            </p:cNvPr>
            <p:cNvGrpSpPr/>
            <p:nvPr/>
          </p:nvGrpSpPr>
          <p:grpSpPr>
            <a:xfrm>
              <a:off x="1249093" y="4064503"/>
              <a:ext cx="302970" cy="1039467"/>
              <a:chOff x="1469522" y="2267701"/>
              <a:chExt cx="356436" cy="1222903"/>
            </a:xfrm>
          </p:grpSpPr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B0EEE21B-8A82-4712-BB53-1D0D3015BF32}"/>
                  </a:ext>
                </a:extLst>
              </p:cNvPr>
              <p:cNvGrpSpPr/>
              <p:nvPr/>
            </p:nvGrpSpPr>
            <p:grpSpPr>
              <a:xfrm>
                <a:off x="1723036" y="2388360"/>
                <a:ext cx="36000" cy="962028"/>
                <a:chOff x="2662036" y="3723079"/>
                <a:chExt cx="36000" cy="962028"/>
              </a:xfrm>
            </p:grpSpPr>
            <p:cxnSp>
              <p:nvCxnSpPr>
                <p:cNvPr id="136" name="Straight Connector 135">
                  <a:extLst>
                    <a:ext uri="{FF2B5EF4-FFF2-40B4-BE49-F238E27FC236}">
                      <a16:creationId xmlns:a16="http://schemas.microsoft.com/office/drawing/2014/main" id="{D9AE2444-E3D9-494C-A12B-809FDF3A41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2036" y="372307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Straight Connector 136">
                  <a:extLst>
                    <a:ext uri="{FF2B5EF4-FFF2-40B4-BE49-F238E27FC236}">
                      <a16:creationId xmlns:a16="http://schemas.microsoft.com/office/drawing/2014/main" id="{23CCE93E-449E-4E46-814F-36E7BEBA16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2036" y="3965965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8" name="Straight Connector 137">
                  <a:extLst>
                    <a:ext uri="{FF2B5EF4-FFF2-40B4-BE49-F238E27FC236}">
                      <a16:creationId xmlns:a16="http://schemas.microsoft.com/office/drawing/2014/main" id="{BDD15C89-1260-4B6B-9587-CF4B4CAB19D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2036" y="4204090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Straight Connector 138">
                  <a:extLst>
                    <a:ext uri="{FF2B5EF4-FFF2-40B4-BE49-F238E27FC236}">
                      <a16:creationId xmlns:a16="http://schemas.microsoft.com/office/drawing/2014/main" id="{87C3C7F5-6383-4163-9084-55122296B54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2036" y="4444603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Straight Connector 139">
                  <a:extLst>
                    <a:ext uri="{FF2B5EF4-FFF2-40B4-BE49-F238E27FC236}">
                      <a16:creationId xmlns:a16="http://schemas.microsoft.com/office/drawing/2014/main" id="{AE764D1F-6CCD-4363-B2D3-60889A37024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62036" y="4685107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E2CB1E8D-5F7F-45B6-91A2-2009B1E871C8}"/>
                  </a:ext>
                </a:extLst>
              </p:cNvPr>
              <p:cNvSpPr txBox="1"/>
              <p:nvPr/>
            </p:nvSpPr>
            <p:spPr>
              <a:xfrm>
                <a:off x="1469523" y="2990843"/>
                <a:ext cx="356435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10</a:t>
                </a:r>
                <a:endParaRPr lang="en-CA" sz="850" baseline="30000" dirty="0"/>
              </a:p>
            </p:txBody>
          </p:sp>
          <p:sp>
            <p:nvSpPr>
              <p:cNvPr id="144" name="TextBox 143">
                <a:extLst>
                  <a:ext uri="{FF2B5EF4-FFF2-40B4-BE49-F238E27FC236}">
                    <a16:creationId xmlns:a16="http://schemas.microsoft.com/office/drawing/2014/main" id="{6D24C7AF-C981-4E85-B3AD-67166D074FCB}"/>
                  </a:ext>
                </a:extLst>
              </p:cNvPr>
              <p:cNvSpPr txBox="1"/>
              <p:nvPr/>
            </p:nvSpPr>
            <p:spPr>
              <a:xfrm>
                <a:off x="1469523" y="2744228"/>
                <a:ext cx="356435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20</a:t>
                </a:r>
                <a:endParaRPr lang="en-CA" sz="850" baseline="30000" dirty="0"/>
              </a:p>
            </p:txBody>
          </p:sp>
          <p:sp>
            <p:nvSpPr>
              <p:cNvPr id="145" name="TextBox 144">
                <a:extLst>
                  <a:ext uri="{FF2B5EF4-FFF2-40B4-BE49-F238E27FC236}">
                    <a16:creationId xmlns:a16="http://schemas.microsoft.com/office/drawing/2014/main" id="{DD6370D6-C321-4371-8AAE-463AEBE67725}"/>
                  </a:ext>
                </a:extLst>
              </p:cNvPr>
              <p:cNvSpPr txBox="1"/>
              <p:nvPr/>
            </p:nvSpPr>
            <p:spPr>
              <a:xfrm>
                <a:off x="1469523" y="2510265"/>
                <a:ext cx="356435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30</a:t>
                </a:r>
                <a:endParaRPr lang="en-CA" sz="850" baseline="30000" dirty="0"/>
              </a:p>
            </p:txBody>
          </p: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D85DD349-6E20-47FE-907E-73C55885A5A8}"/>
                  </a:ext>
                </a:extLst>
              </p:cNvPr>
              <p:cNvSpPr txBox="1"/>
              <p:nvPr/>
            </p:nvSpPr>
            <p:spPr>
              <a:xfrm>
                <a:off x="1469522" y="2267701"/>
                <a:ext cx="356436" cy="41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40</a:t>
                </a:r>
                <a:endParaRPr lang="en-CA" sz="850" baseline="30000" dirty="0"/>
              </a:p>
            </p:txBody>
          </p:sp>
          <p:sp>
            <p:nvSpPr>
              <p:cNvPr id="148" name="TextBox 147">
                <a:extLst>
                  <a:ext uri="{FF2B5EF4-FFF2-40B4-BE49-F238E27FC236}">
                    <a16:creationId xmlns:a16="http://schemas.microsoft.com/office/drawing/2014/main" id="{E5AEDF99-ED6D-4825-83B9-7ACFCA13E403}"/>
                  </a:ext>
                </a:extLst>
              </p:cNvPr>
              <p:cNvSpPr txBox="1"/>
              <p:nvPr/>
            </p:nvSpPr>
            <p:spPr>
              <a:xfrm>
                <a:off x="1537926" y="3228089"/>
                <a:ext cx="288032" cy="262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0</a:t>
                </a:r>
                <a:endParaRPr lang="en-CA" sz="850" baseline="30000" dirty="0"/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0FD44B2B-2A28-C572-586B-301BC5B44C39}"/>
                </a:ext>
              </a:extLst>
            </p:cNvPr>
            <p:cNvGrpSpPr/>
            <p:nvPr/>
          </p:nvGrpSpPr>
          <p:grpSpPr>
            <a:xfrm>
              <a:off x="1355274" y="4161076"/>
              <a:ext cx="2201526" cy="1205929"/>
              <a:chOff x="1355274" y="4161076"/>
              <a:chExt cx="2201526" cy="1205929"/>
            </a:xfrm>
          </p:grpSpPr>
          <p:grpSp>
            <p:nvGrpSpPr>
              <p:cNvPr id="128" name="Group 127">
                <a:extLst>
                  <a:ext uri="{FF2B5EF4-FFF2-40B4-BE49-F238E27FC236}">
                    <a16:creationId xmlns:a16="http://schemas.microsoft.com/office/drawing/2014/main" id="{970D374A-C442-4D73-9733-C042A438D7BE}"/>
                  </a:ext>
                </a:extLst>
              </p:cNvPr>
              <p:cNvGrpSpPr/>
              <p:nvPr/>
            </p:nvGrpSpPr>
            <p:grpSpPr>
              <a:xfrm>
                <a:off x="1355274" y="4161076"/>
                <a:ext cx="2201526" cy="1191217"/>
                <a:chOff x="249735" y="2290498"/>
                <a:chExt cx="2590030" cy="1401432"/>
              </a:xfrm>
            </p:grpSpPr>
            <p:pic>
              <p:nvPicPr>
                <p:cNvPr id="2" name="Picture 1">
                  <a:extLst>
                    <a:ext uri="{FF2B5EF4-FFF2-40B4-BE49-F238E27FC236}">
                      <a16:creationId xmlns:a16="http://schemas.microsoft.com/office/drawing/2014/main" id="{6C48DCEC-B7C1-4229-90CA-0F4283C6E5B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grayscl/>
                </a:blip>
                <a:srcRect l="8230" t="13089" r="7188" b="13160"/>
                <a:stretch/>
              </p:blipFill>
              <p:spPr>
                <a:xfrm>
                  <a:off x="424815" y="2290498"/>
                  <a:ext cx="2279207" cy="98335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92" name="Group 91">
                  <a:extLst>
                    <a:ext uri="{FF2B5EF4-FFF2-40B4-BE49-F238E27FC236}">
                      <a16:creationId xmlns:a16="http://schemas.microsoft.com/office/drawing/2014/main" id="{53B5FF06-5999-4C3D-9FCE-5F77AD8550E8}"/>
                    </a:ext>
                  </a:extLst>
                </p:cNvPr>
                <p:cNvGrpSpPr/>
                <p:nvPr/>
              </p:nvGrpSpPr>
              <p:grpSpPr>
                <a:xfrm>
                  <a:off x="249735" y="3275526"/>
                  <a:ext cx="2590030" cy="416404"/>
                  <a:chOff x="249735" y="3580326"/>
                  <a:chExt cx="2590030" cy="416404"/>
                </a:xfrm>
              </p:grpSpPr>
              <p:grpSp>
                <p:nvGrpSpPr>
                  <p:cNvPr id="31" name="Group 30">
                    <a:extLst>
                      <a:ext uri="{FF2B5EF4-FFF2-40B4-BE49-F238E27FC236}">
                        <a16:creationId xmlns:a16="http://schemas.microsoft.com/office/drawing/2014/main" id="{32F58492-491E-4046-A7D6-2319EEE1EBA7}"/>
                      </a:ext>
                    </a:extLst>
                  </p:cNvPr>
                  <p:cNvGrpSpPr/>
                  <p:nvPr/>
                </p:nvGrpSpPr>
                <p:grpSpPr>
                  <a:xfrm>
                    <a:off x="249735" y="3580326"/>
                    <a:ext cx="348519" cy="416404"/>
                    <a:chOff x="1275543" y="1764818"/>
                    <a:chExt cx="348519" cy="416404"/>
                  </a:xfrm>
                </p:grpSpPr>
                <p:cxnSp>
                  <p:nvCxnSpPr>
                    <p:cNvPr id="32" name="Straight Connector 31">
                      <a:extLst>
                        <a:ext uri="{FF2B5EF4-FFF2-40B4-BE49-F238E27FC236}">
                          <a16:creationId xmlns:a16="http://schemas.microsoft.com/office/drawing/2014/main" id="{4A556A00-2A1F-4EED-A615-048289C09833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3C8976C1-7DDC-42BC-A7DD-4DD396B16E2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75543" y="1764818"/>
                      <a:ext cx="348519" cy="416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-3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34" name="Group 33">
                    <a:extLst>
                      <a:ext uri="{FF2B5EF4-FFF2-40B4-BE49-F238E27FC236}">
                        <a16:creationId xmlns:a16="http://schemas.microsoft.com/office/drawing/2014/main" id="{3B3F3492-D279-43C6-AAD3-D5A3CEC3CF89}"/>
                      </a:ext>
                    </a:extLst>
                  </p:cNvPr>
                  <p:cNvGrpSpPr/>
                  <p:nvPr/>
                </p:nvGrpSpPr>
                <p:grpSpPr>
                  <a:xfrm>
                    <a:off x="510050" y="3580326"/>
                    <a:ext cx="348519" cy="416404"/>
                    <a:chOff x="1275543" y="1764818"/>
                    <a:chExt cx="348519" cy="416404"/>
                  </a:xfrm>
                </p:grpSpPr>
                <p:cxnSp>
                  <p:nvCxnSpPr>
                    <p:cNvPr id="35" name="Straight Connector 34">
                      <a:extLst>
                        <a:ext uri="{FF2B5EF4-FFF2-40B4-BE49-F238E27FC236}">
                          <a16:creationId xmlns:a16="http://schemas.microsoft.com/office/drawing/2014/main" id="{E708FDEA-4131-4D68-9CE0-2C2B336E7213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FCD15669-06A5-458C-8110-C2CED7F0028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75543" y="1764818"/>
                      <a:ext cx="348519" cy="416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-2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37" name="Group 36">
                    <a:extLst>
                      <a:ext uri="{FF2B5EF4-FFF2-40B4-BE49-F238E27FC236}">
                        <a16:creationId xmlns:a16="http://schemas.microsoft.com/office/drawing/2014/main" id="{A7BA957A-762F-482E-9326-6E9A9834DB21}"/>
                      </a:ext>
                    </a:extLst>
                  </p:cNvPr>
                  <p:cNvGrpSpPr/>
                  <p:nvPr/>
                </p:nvGrpSpPr>
                <p:grpSpPr>
                  <a:xfrm>
                    <a:off x="763866" y="3580326"/>
                    <a:ext cx="348519" cy="416404"/>
                    <a:chOff x="1275543" y="1764818"/>
                    <a:chExt cx="348519" cy="416404"/>
                  </a:xfrm>
                </p:grpSpPr>
                <p:cxnSp>
                  <p:nvCxnSpPr>
                    <p:cNvPr id="38" name="Straight Connector 37">
                      <a:extLst>
                        <a:ext uri="{FF2B5EF4-FFF2-40B4-BE49-F238E27FC236}">
                          <a16:creationId xmlns:a16="http://schemas.microsoft.com/office/drawing/2014/main" id="{A70AC396-F4AD-42BD-A8C7-0098D4E9A55F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84E6FC98-EAB1-45D6-9101-59FC313F441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75543" y="1764818"/>
                      <a:ext cx="348519" cy="41640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-1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40" name="Group 39">
                    <a:extLst>
                      <a:ext uri="{FF2B5EF4-FFF2-40B4-BE49-F238E27FC236}">
                        <a16:creationId xmlns:a16="http://schemas.microsoft.com/office/drawing/2014/main" id="{E6628DAA-FDE9-4146-A66E-0A77AF283346}"/>
                      </a:ext>
                    </a:extLst>
                  </p:cNvPr>
                  <p:cNvGrpSpPr/>
                  <p:nvPr/>
                </p:nvGrpSpPr>
                <p:grpSpPr>
                  <a:xfrm>
                    <a:off x="1041916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41" name="Straight Connector 40">
                      <a:extLst>
                        <a:ext uri="{FF2B5EF4-FFF2-40B4-BE49-F238E27FC236}">
                          <a16:creationId xmlns:a16="http://schemas.microsoft.com/office/drawing/2014/main" id="{A9D2297A-15B1-43AD-950C-A496D04D9387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2" name="TextBox 41">
                      <a:extLst>
                        <a:ext uri="{FF2B5EF4-FFF2-40B4-BE49-F238E27FC236}">
                          <a16:creationId xmlns:a16="http://schemas.microsoft.com/office/drawing/2014/main" id="{938984B6-4058-44E7-B637-347A8C447C5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0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43" name="Group 42">
                    <a:extLst>
                      <a:ext uri="{FF2B5EF4-FFF2-40B4-BE49-F238E27FC236}">
                        <a16:creationId xmlns:a16="http://schemas.microsoft.com/office/drawing/2014/main" id="{7AB16342-2360-4434-A7AC-6D8C565B852F}"/>
                      </a:ext>
                    </a:extLst>
                  </p:cNvPr>
                  <p:cNvGrpSpPr/>
                  <p:nvPr/>
                </p:nvGrpSpPr>
                <p:grpSpPr>
                  <a:xfrm>
                    <a:off x="1296449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44" name="Straight Connector 43">
                      <a:extLst>
                        <a:ext uri="{FF2B5EF4-FFF2-40B4-BE49-F238E27FC236}">
                          <a16:creationId xmlns:a16="http://schemas.microsoft.com/office/drawing/2014/main" id="{5829F8E9-FAB7-43E1-A96F-D71D615FF851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5" name="TextBox 44">
                      <a:extLst>
                        <a:ext uri="{FF2B5EF4-FFF2-40B4-BE49-F238E27FC236}">
                          <a16:creationId xmlns:a16="http://schemas.microsoft.com/office/drawing/2014/main" id="{BAB16724-040D-4BBA-9464-0A801A1018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1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46" name="Group 45">
                    <a:extLst>
                      <a:ext uri="{FF2B5EF4-FFF2-40B4-BE49-F238E27FC236}">
                        <a16:creationId xmlns:a16="http://schemas.microsoft.com/office/drawing/2014/main" id="{3EEB30B4-38B0-4234-8CF0-6B0D097740EB}"/>
                      </a:ext>
                    </a:extLst>
                  </p:cNvPr>
                  <p:cNvGrpSpPr/>
                  <p:nvPr/>
                </p:nvGrpSpPr>
                <p:grpSpPr>
                  <a:xfrm>
                    <a:off x="1546006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47" name="Straight Connector 46">
                      <a:extLst>
                        <a:ext uri="{FF2B5EF4-FFF2-40B4-BE49-F238E27FC236}">
                          <a16:creationId xmlns:a16="http://schemas.microsoft.com/office/drawing/2014/main" id="{F3339312-0753-490B-AB1A-FB34AC3E1D0B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48" name="TextBox 47">
                      <a:extLst>
                        <a:ext uri="{FF2B5EF4-FFF2-40B4-BE49-F238E27FC236}">
                          <a16:creationId xmlns:a16="http://schemas.microsoft.com/office/drawing/2014/main" id="{23DA2DCF-58D3-45AA-A67D-47B63C3278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2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49" name="Group 48">
                    <a:extLst>
                      <a:ext uri="{FF2B5EF4-FFF2-40B4-BE49-F238E27FC236}">
                        <a16:creationId xmlns:a16="http://schemas.microsoft.com/office/drawing/2014/main" id="{164C5FFD-41D9-4E26-9AEF-863A4EB56E1A}"/>
                      </a:ext>
                    </a:extLst>
                  </p:cNvPr>
                  <p:cNvGrpSpPr/>
                  <p:nvPr/>
                </p:nvGrpSpPr>
                <p:grpSpPr>
                  <a:xfrm>
                    <a:off x="1797875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50" name="Straight Connector 49">
                      <a:extLst>
                        <a:ext uri="{FF2B5EF4-FFF2-40B4-BE49-F238E27FC236}">
                          <a16:creationId xmlns:a16="http://schemas.microsoft.com/office/drawing/2014/main" id="{02F388A2-B1A1-4AB1-A922-6B77ADF0D93E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1" name="TextBox 50">
                      <a:extLst>
                        <a:ext uri="{FF2B5EF4-FFF2-40B4-BE49-F238E27FC236}">
                          <a16:creationId xmlns:a16="http://schemas.microsoft.com/office/drawing/2014/main" id="{50F4BE24-07E2-4FBE-BCA3-2272A83CDF4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3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52" name="Group 51">
                    <a:extLst>
                      <a:ext uri="{FF2B5EF4-FFF2-40B4-BE49-F238E27FC236}">
                        <a16:creationId xmlns:a16="http://schemas.microsoft.com/office/drawing/2014/main" id="{3E6A15DC-B3D8-4396-B8B7-3EB55EDA8AFE}"/>
                      </a:ext>
                    </a:extLst>
                  </p:cNvPr>
                  <p:cNvGrpSpPr/>
                  <p:nvPr/>
                </p:nvGrpSpPr>
                <p:grpSpPr>
                  <a:xfrm>
                    <a:off x="2049102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53" name="Straight Connector 52">
                      <a:extLst>
                        <a:ext uri="{FF2B5EF4-FFF2-40B4-BE49-F238E27FC236}">
                          <a16:creationId xmlns:a16="http://schemas.microsoft.com/office/drawing/2014/main" id="{D4CDD2B2-B4D1-4468-991A-3D600F195F99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4" name="TextBox 53">
                      <a:extLst>
                        <a:ext uri="{FF2B5EF4-FFF2-40B4-BE49-F238E27FC236}">
                          <a16:creationId xmlns:a16="http://schemas.microsoft.com/office/drawing/2014/main" id="{466A4900-8993-40E1-A982-03CBB3FD9A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4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55" name="Group 54">
                    <a:extLst>
                      <a:ext uri="{FF2B5EF4-FFF2-40B4-BE49-F238E27FC236}">
                        <a16:creationId xmlns:a16="http://schemas.microsoft.com/office/drawing/2014/main" id="{352FFAE5-3C2E-431E-85FD-38C1E9547FAD}"/>
                      </a:ext>
                    </a:extLst>
                  </p:cNvPr>
                  <p:cNvGrpSpPr/>
                  <p:nvPr/>
                </p:nvGrpSpPr>
                <p:grpSpPr>
                  <a:xfrm>
                    <a:off x="2301475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56" name="Straight Connector 55">
                      <a:extLst>
                        <a:ext uri="{FF2B5EF4-FFF2-40B4-BE49-F238E27FC236}">
                          <a16:creationId xmlns:a16="http://schemas.microsoft.com/office/drawing/2014/main" id="{DE5F553C-70CE-4D31-8214-30EC3E772BE0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7" name="TextBox 56">
                      <a:extLst>
                        <a:ext uri="{FF2B5EF4-FFF2-40B4-BE49-F238E27FC236}">
                          <a16:creationId xmlns:a16="http://schemas.microsoft.com/office/drawing/2014/main" id="{86DF7517-064D-4BC0-8039-5B4B0787EF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5</a:t>
                      </a:r>
                      <a:endParaRPr lang="en-CA" sz="850" baseline="30000" dirty="0"/>
                    </a:p>
                  </p:txBody>
                </p:sp>
              </p:grpSp>
              <p:grpSp>
                <p:nvGrpSpPr>
                  <p:cNvPr id="58" name="Group 57">
                    <a:extLst>
                      <a:ext uri="{FF2B5EF4-FFF2-40B4-BE49-F238E27FC236}">
                        <a16:creationId xmlns:a16="http://schemas.microsoft.com/office/drawing/2014/main" id="{21794E18-2F3A-40D9-91CC-DA466761F019}"/>
                      </a:ext>
                    </a:extLst>
                  </p:cNvPr>
                  <p:cNvGrpSpPr/>
                  <p:nvPr/>
                </p:nvGrpSpPr>
                <p:grpSpPr>
                  <a:xfrm>
                    <a:off x="2551733" y="3580326"/>
                    <a:ext cx="288032" cy="262516"/>
                    <a:chOff x="1305787" y="1764818"/>
                    <a:chExt cx="288032" cy="262516"/>
                  </a:xfrm>
                </p:grpSpPr>
                <p:cxnSp>
                  <p:nvCxnSpPr>
                    <p:cNvPr id="59" name="Straight Connector 58">
                      <a:extLst>
                        <a:ext uri="{FF2B5EF4-FFF2-40B4-BE49-F238E27FC236}">
                          <a16:creationId xmlns:a16="http://schemas.microsoft.com/office/drawing/2014/main" id="{F9C22D58-725D-45CB-931A-3F5E7225ECAB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1432091" y="1791969"/>
                      <a:ext cx="36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60" name="TextBox 59">
                      <a:extLst>
                        <a:ext uri="{FF2B5EF4-FFF2-40B4-BE49-F238E27FC236}">
                          <a16:creationId xmlns:a16="http://schemas.microsoft.com/office/drawing/2014/main" id="{40FF5E2A-8EDA-45C8-AB85-8F0969A163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5787" y="1764818"/>
                      <a:ext cx="288032" cy="2625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CA" sz="850" dirty="0"/>
                        <a:t>6</a:t>
                      </a:r>
                      <a:endParaRPr lang="en-CA" sz="850" baseline="30000" dirty="0"/>
                    </a:p>
                  </p:txBody>
                </p:sp>
              </p:grpSp>
            </p:grpSp>
          </p:grp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97498A18-E2A3-472A-BDAA-2FE754C1B1E0}"/>
                  </a:ext>
                </a:extLst>
              </p:cNvPr>
              <p:cNvSpPr txBox="1"/>
              <p:nvPr/>
            </p:nvSpPr>
            <p:spPr>
              <a:xfrm>
                <a:off x="2059556" y="5130786"/>
                <a:ext cx="796262" cy="2362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935" dirty="0"/>
                  <a:t>Log ng DNA</a:t>
                </a:r>
                <a:endParaRPr lang="en-CA" sz="935" baseline="30000" dirty="0"/>
              </a:p>
            </p:txBody>
          </p:sp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B8439B04-4B53-46D6-BC53-1AD56823A345}"/>
                  </a:ext>
                </a:extLst>
              </p:cNvPr>
              <p:cNvSpPr txBox="1"/>
              <p:nvPr/>
            </p:nvSpPr>
            <p:spPr>
              <a:xfrm>
                <a:off x="2241968" y="4203374"/>
                <a:ext cx="1272271" cy="190758"/>
              </a:xfrm>
              <a:prstGeom prst="rect">
                <a:avLst/>
              </a:prstGeom>
              <a:noFill/>
            </p:spPr>
            <p:txBody>
              <a:bodyPr wrap="square" tIns="0" bIns="0" rtlCol="0">
                <a:spAutoFit/>
              </a:bodyPr>
              <a:lstStyle/>
              <a:p>
                <a:pPr>
                  <a:lnSpc>
                    <a:spcPct val="80000"/>
                  </a:lnSpc>
                </a:pPr>
                <a:r>
                  <a:rPr lang="en-CA" sz="765" dirty="0"/>
                  <a:t>R</a:t>
                </a:r>
                <a:r>
                  <a:rPr lang="en-CA" sz="765" baseline="30000" dirty="0"/>
                  <a:t>2</a:t>
                </a:r>
                <a:r>
                  <a:rPr lang="en-CA" sz="765" dirty="0"/>
                  <a:t> 0.999; Y = -3.4x + 28.7</a:t>
                </a: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19031A9F-845B-432E-AA29-FB98374D1B70}"/>
                  </a:ext>
                </a:extLst>
              </p:cNvPr>
              <p:cNvSpPr txBox="1"/>
              <p:nvPr/>
            </p:nvSpPr>
            <p:spPr>
              <a:xfrm>
                <a:off x="1460184" y="4872071"/>
                <a:ext cx="1534269" cy="96565"/>
              </a:xfrm>
              <a:prstGeom prst="rect">
                <a:avLst/>
              </a:prstGeom>
              <a:noFill/>
            </p:spPr>
            <p:txBody>
              <a:bodyPr wrap="square" tIns="0" bIns="0" rtlCol="0">
                <a:spAutoFit/>
              </a:bodyPr>
              <a:lstStyle/>
              <a:p>
                <a:pPr>
                  <a:lnSpc>
                    <a:spcPct val="80000"/>
                  </a:lnSpc>
                </a:pPr>
                <a:r>
                  <a:rPr lang="en-CA" sz="765" dirty="0"/>
                  <a:t>AciHV-3 DNA positive tissue</a:t>
                </a:r>
              </a:p>
            </p:txBody>
          </p:sp>
        </p:grpSp>
      </p:grpSp>
      <p:sp>
        <p:nvSpPr>
          <p:cNvPr id="212" name="TextBox 211">
            <a:extLst>
              <a:ext uri="{FF2B5EF4-FFF2-40B4-BE49-F238E27FC236}">
                <a16:creationId xmlns:a16="http://schemas.microsoft.com/office/drawing/2014/main" id="{ABA976B7-F8DB-4809-97AD-56BDBAF49F38}"/>
              </a:ext>
            </a:extLst>
          </p:cNvPr>
          <p:cNvSpPr txBox="1"/>
          <p:nvPr/>
        </p:nvSpPr>
        <p:spPr>
          <a:xfrm>
            <a:off x="859277" y="2755149"/>
            <a:ext cx="260008" cy="2492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20" dirty="0"/>
              <a:t>A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57869B9-69EC-2FAA-92DE-7B720DC09559}"/>
              </a:ext>
            </a:extLst>
          </p:cNvPr>
          <p:cNvGrpSpPr/>
          <p:nvPr/>
        </p:nvGrpSpPr>
        <p:grpSpPr>
          <a:xfrm>
            <a:off x="1223975" y="5320661"/>
            <a:ext cx="2308685" cy="1313585"/>
            <a:chOff x="1223975" y="5320661"/>
            <a:chExt cx="2308685" cy="1313585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E9BB49E-E4C5-41A4-9A1B-3CEFA61ABE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grayscl/>
            </a:blip>
            <a:srcRect l="8281" t="13272" r="7240" b="13377"/>
            <a:stretch/>
          </p:blipFill>
          <p:spPr>
            <a:xfrm>
              <a:off x="1480031" y="5414926"/>
              <a:ext cx="1937326" cy="8492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7DDD1EC5-4B93-4E7D-A9A1-EA5FDB9A4F9A}"/>
                </a:ext>
              </a:extLst>
            </p:cNvPr>
            <p:cNvSpPr txBox="1"/>
            <p:nvPr/>
          </p:nvSpPr>
          <p:spPr>
            <a:xfrm>
              <a:off x="2059556" y="6398027"/>
              <a:ext cx="796262" cy="23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935" dirty="0"/>
                <a:t>Log copies</a:t>
              </a:r>
              <a:endParaRPr lang="en-CA" sz="935" baseline="30000" dirty="0"/>
            </a:p>
          </p:txBody>
        </p:sp>
        <p:grpSp>
          <p:nvGrpSpPr>
            <p:cNvPr id="176" name="Group 175">
              <a:extLst>
                <a:ext uri="{FF2B5EF4-FFF2-40B4-BE49-F238E27FC236}">
                  <a16:creationId xmlns:a16="http://schemas.microsoft.com/office/drawing/2014/main" id="{52D48DB3-908C-4A00-8CD5-E8F999E285EE}"/>
                </a:ext>
              </a:extLst>
            </p:cNvPr>
            <p:cNvGrpSpPr/>
            <p:nvPr/>
          </p:nvGrpSpPr>
          <p:grpSpPr>
            <a:xfrm>
              <a:off x="1223975" y="5320661"/>
              <a:ext cx="302970" cy="1051611"/>
              <a:chOff x="1439971" y="3952870"/>
              <a:chExt cx="356436" cy="1237189"/>
            </a:xfrm>
          </p:grpSpPr>
          <p:cxnSp>
            <p:nvCxnSpPr>
              <p:cNvPr id="166" name="Straight Connector 165">
                <a:extLst>
                  <a:ext uri="{FF2B5EF4-FFF2-40B4-BE49-F238E27FC236}">
                    <a16:creationId xmlns:a16="http://schemas.microsoft.com/office/drawing/2014/main" id="{1F75D356-9CBC-4556-B827-3732B90B6F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3485" y="4073529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Straight Connector 166">
                <a:extLst>
                  <a:ext uri="{FF2B5EF4-FFF2-40B4-BE49-F238E27FC236}">
                    <a16:creationId xmlns:a16="http://schemas.microsoft.com/office/drawing/2014/main" id="{0E5FCB1A-13DB-4341-9DDF-5293D3CB453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3485" y="4316415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Connector 167">
                <a:extLst>
                  <a:ext uri="{FF2B5EF4-FFF2-40B4-BE49-F238E27FC236}">
                    <a16:creationId xmlns:a16="http://schemas.microsoft.com/office/drawing/2014/main" id="{D78CEE16-2F09-48F3-92A4-04A85F5A64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3485" y="4561683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168">
                <a:extLst>
                  <a:ext uri="{FF2B5EF4-FFF2-40B4-BE49-F238E27FC236}">
                    <a16:creationId xmlns:a16="http://schemas.microsoft.com/office/drawing/2014/main" id="{F5161FCC-63C6-41A9-865C-B719B4A3A92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3485" y="4806958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>
                <a:extLst>
                  <a:ext uri="{FF2B5EF4-FFF2-40B4-BE49-F238E27FC236}">
                    <a16:creationId xmlns:a16="http://schemas.microsoft.com/office/drawing/2014/main" id="{85906B0E-E41A-41C7-959B-E807E77FF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3485" y="5049843"/>
                <a:ext cx="36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8B4F8AFB-0C78-4087-B4C2-0F799425E4DC}"/>
                  </a:ext>
                </a:extLst>
              </p:cNvPr>
              <p:cNvSpPr txBox="1"/>
              <p:nvPr/>
            </p:nvSpPr>
            <p:spPr>
              <a:xfrm>
                <a:off x="1439972" y="4683156"/>
                <a:ext cx="356435" cy="41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10</a:t>
                </a:r>
                <a:endParaRPr lang="en-CA" sz="850" baseline="30000" dirty="0"/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DFBABC16-A8F8-464C-BBCC-7A046D6EAE90}"/>
                  </a:ext>
                </a:extLst>
              </p:cNvPr>
              <p:cNvSpPr txBox="1"/>
              <p:nvPr/>
            </p:nvSpPr>
            <p:spPr>
              <a:xfrm>
                <a:off x="1439972" y="4441302"/>
                <a:ext cx="356435" cy="41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20</a:t>
                </a:r>
                <a:endParaRPr lang="en-CA" sz="850" baseline="30000" dirty="0"/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36DC3591-8004-45E6-9194-E848B74B8B80}"/>
                  </a:ext>
                </a:extLst>
              </p:cNvPr>
              <p:cNvSpPr txBox="1"/>
              <p:nvPr/>
            </p:nvSpPr>
            <p:spPr>
              <a:xfrm>
                <a:off x="1439972" y="4195433"/>
                <a:ext cx="356435" cy="41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30</a:t>
                </a:r>
                <a:endParaRPr lang="en-CA" sz="850" baseline="30000" dirty="0"/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1E79CEEC-831B-4AF4-ADD4-C7536BF64663}"/>
                  </a:ext>
                </a:extLst>
              </p:cNvPr>
              <p:cNvSpPr txBox="1"/>
              <p:nvPr/>
            </p:nvSpPr>
            <p:spPr>
              <a:xfrm>
                <a:off x="1439971" y="3952870"/>
                <a:ext cx="356436" cy="4164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40</a:t>
                </a:r>
                <a:endParaRPr lang="en-CA" sz="850" baseline="30000" dirty="0"/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8F089A7B-C660-4350-8FD8-9C0F28221BEE}"/>
                  </a:ext>
                </a:extLst>
              </p:cNvPr>
              <p:cNvSpPr txBox="1"/>
              <p:nvPr/>
            </p:nvSpPr>
            <p:spPr>
              <a:xfrm>
                <a:off x="1508375" y="4927544"/>
                <a:ext cx="288032" cy="262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850" dirty="0"/>
                  <a:t>0</a:t>
                </a:r>
                <a:endParaRPr lang="en-CA" sz="850" baseline="30000" dirty="0"/>
              </a:p>
            </p:txBody>
          </p:sp>
        </p:grp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3A552569-DD4A-4E30-B822-01D2F4ACA4F8}"/>
                </a:ext>
              </a:extLst>
            </p:cNvPr>
            <p:cNvSpPr txBox="1"/>
            <p:nvPr/>
          </p:nvSpPr>
          <p:spPr>
            <a:xfrm>
              <a:off x="2216906" y="5461285"/>
              <a:ext cx="1264828" cy="190758"/>
            </a:xfrm>
            <a:prstGeom prst="rect">
              <a:avLst/>
            </a:prstGeom>
            <a:noFill/>
          </p:spPr>
          <p:txBody>
            <a:bodyPr wrap="square" tIns="0" bIns="0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en-CA" sz="765" dirty="0"/>
                <a:t>R</a:t>
              </a:r>
              <a:r>
                <a:rPr lang="en-CA" sz="765" baseline="30000" dirty="0"/>
                <a:t>2</a:t>
              </a:r>
              <a:r>
                <a:rPr lang="en-CA" sz="765" dirty="0"/>
                <a:t> 0.996; Y = -3.4x + 38.4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F3B33998-D619-41B6-AFBC-5935A907500F}"/>
                </a:ext>
              </a:extLst>
            </p:cNvPr>
            <p:cNvSpPr txBox="1"/>
            <p:nvPr/>
          </p:nvSpPr>
          <p:spPr>
            <a:xfrm>
              <a:off x="1443991" y="6142456"/>
              <a:ext cx="930726" cy="96565"/>
            </a:xfrm>
            <a:prstGeom prst="rect">
              <a:avLst/>
            </a:prstGeom>
            <a:noFill/>
          </p:spPr>
          <p:txBody>
            <a:bodyPr wrap="square" tIns="0" bIns="0" rtlCol="0">
              <a:spAutoFit/>
            </a:bodyPr>
            <a:lstStyle/>
            <a:p>
              <a:pPr>
                <a:lnSpc>
                  <a:spcPct val="80000"/>
                </a:lnSpc>
              </a:pPr>
              <a:r>
                <a:rPr lang="en-CA" sz="765" dirty="0"/>
                <a:t>pAciHV-3-mcp</a:t>
              </a:r>
            </a:p>
          </p:txBody>
        </p:sp>
        <p:grpSp>
          <p:nvGrpSpPr>
            <p:cNvPr id="245" name="Group 244">
              <a:extLst>
                <a:ext uri="{FF2B5EF4-FFF2-40B4-BE49-F238E27FC236}">
                  <a16:creationId xmlns:a16="http://schemas.microsoft.com/office/drawing/2014/main" id="{11ADE764-6D8E-4ADF-9958-AFD145FD5A89}"/>
                </a:ext>
              </a:extLst>
            </p:cNvPr>
            <p:cNvGrpSpPr/>
            <p:nvPr/>
          </p:nvGrpSpPr>
          <p:grpSpPr>
            <a:xfrm>
              <a:off x="1365709" y="6263438"/>
              <a:ext cx="2166951" cy="223139"/>
              <a:chOff x="1606716" y="4881044"/>
              <a:chExt cx="2549354" cy="262516"/>
            </a:xfrm>
          </p:grpSpPr>
          <p:grpSp>
            <p:nvGrpSpPr>
              <p:cNvPr id="215" name="Group 214">
                <a:extLst>
                  <a:ext uri="{FF2B5EF4-FFF2-40B4-BE49-F238E27FC236}">
                    <a16:creationId xmlns:a16="http://schemas.microsoft.com/office/drawing/2014/main" id="{26756AFE-7672-4F26-9895-046858B436B6}"/>
                  </a:ext>
                </a:extLst>
              </p:cNvPr>
              <p:cNvGrpSpPr/>
              <p:nvPr/>
            </p:nvGrpSpPr>
            <p:grpSpPr>
              <a:xfrm>
                <a:off x="1859216" y="4881044"/>
                <a:ext cx="288032" cy="262516"/>
                <a:chOff x="1305787" y="1764818"/>
                <a:chExt cx="288032" cy="262516"/>
              </a:xfrm>
            </p:grpSpPr>
            <p:cxnSp>
              <p:nvCxnSpPr>
                <p:cNvPr id="237" name="Straight Connector 236">
                  <a:extLst>
                    <a:ext uri="{FF2B5EF4-FFF2-40B4-BE49-F238E27FC236}">
                      <a16:creationId xmlns:a16="http://schemas.microsoft.com/office/drawing/2014/main" id="{AF9EE308-FA4A-4C58-98B8-61F0C8F8B0F6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TextBox 237">
                  <a:extLst>
                    <a:ext uri="{FF2B5EF4-FFF2-40B4-BE49-F238E27FC236}">
                      <a16:creationId xmlns:a16="http://schemas.microsoft.com/office/drawing/2014/main" id="{62329992-8E95-4651-8E40-3BB7171A6655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1</a:t>
                  </a:r>
                  <a:endParaRPr lang="en-CA" sz="850" baseline="30000" dirty="0"/>
                </a:p>
              </p:txBody>
            </p:sp>
          </p:grpSp>
          <p:grpSp>
            <p:nvGrpSpPr>
              <p:cNvPr id="216" name="Group 215">
                <a:extLst>
                  <a:ext uri="{FF2B5EF4-FFF2-40B4-BE49-F238E27FC236}">
                    <a16:creationId xmlns:a16="http://schemas.microsoft.com/office/drawing/2014/main" id="{93DDC2D5-8CD1-4F01-B6D4-AA0D74BF7DC0}"/>
                  </a:ext>
                </a:extLst>
              </p:cNvPr>
              <p:cNvGrpSpPr/>
              <p:nvPr/>
            </p:nvGrpSpPr>
            <p:grpSpPr>
              <a:xfrm>
                <a:off x="2108269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35" name="Straight Connector 234">
                  <a:extLst>
                    <a:ext uri="{FF2B5EF4-FFF2-40B4-BE49-F238E27FC236}">
                      <a16:creationId xmlns:a16="http://schemas.microsoft.com/office/drawing/2014/main" id="{797C89A1-D497-447D-A6C5-DA7D74FD11CC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6" name="TextBox 235">
                  <a:extLst>
                    <a:ext uri="{FF2B5EF4-FFF2-40B4-BE49-F238E27FC236}">
                      <a16:creationId xmlns:a16="http://schemas.microsoft.com/office/drawing/2014/main" id="{72A0B2EC-F5C8-4481-84F7-4C780E65420A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2</a:t>
                  </a:r>
                  <a:endParaRPr lang="en-CA" sz="850" baseline="30000" dirty="0"/>
                </a:p>
              </p:txBody>
            </p:sp>
          </p:grpSp>
          <p:grpSp>
            <p:nvGrpSpPr>
              <p:cNvPr id="217" name="Group 216">
                <a:extLst>
                  <a:ext uri="{FF2B5EF4-FFF2-40B4-BE49-F238E27FC236}">
                    <a16:creationId xmlns:a16="http://schemas.microsoft.com/office/drawing/2014/main" id="{905A6C59-D83A-4C81-ADEE-F818B41A993E}"/>
                  </a:ext>
                </a:extLst>
              </p:cNvPr>
              <p:cNvGrpSpPr/>
              <p:nvPr/>
            </p:nvGrpSpPr>
            <p:grpSpPr>
              <a:xfrm>
                <a:off x="2360842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33" name="Straight Connector 232">
                  <a:extLst>
                    <a:ext uri="{FF2B5EF4-FFF2-40B4-BE49-F238E27FC236}">
                      <a16:creationId xmlns:a16="http://schemas.microsoft.com/office/drawing/2014/main" id="{281E0639-3EC9-4E6C-A475-561096F2C4CE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TextBox 233">
                  <a:extLst>
                    <a:ext uri="{FF2B5EF4-FFF2-40B4-BE49-F238E27FC236}">
                      <a16:creationId xmlns:a16="http://schemas.microsoft.com/office/drawing/2014/main" id="{0C753EF0-AF2F-441B-94F1-36877B73D971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3</a:t>
                  </a:r>
                  <a:endParaRPr lang="en-CA" sz="850" baseline="30000" dirty="0"/>
                </a:p>
              </p:txBody>
            </p:sp>
          </p:grpSp>
          <p:grpSp>
            <p:nvGrpSpPr>
              <p:cNvPr id="218" name="Group 217">
                <a:extLst>
                  <a:ext uri="{FF2B5EF4-FFF2-40B4-BE49-F238E27FC236}">
                    <a16:creationId xmlns:a16="http://schemas.microsoft.com/office/drawing/2014/main" id="{EEDB7C4C-823C-4FCD-97F2-B34BD4BFC650}"/>
                  </a:ext>
                </a:extLst>
              </p:cNvPr>
              <p:cNvGrpSpPr/>
              <p:nvPr/>
            </p:nvGrpSpPr>
            <p:grpSpPr>
              <a:xfrm>
                <a:off x="2609817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31" name="Straight Connector 230">
                  <a:extLst>
                    <a:ext uri="{FF2B5EF4-FFF2-40B4-BE49-F238E27FC236}">
                      <a16:creationId xmlns:a16="http://schemas.microsoft.com/office/drawing/2014/main" id="{59B374C9-B1CF-448E-8EAA-5FCFC0DA64CF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2" name="TextBox 231">
                  <a:extLst>
                    <a:ext uri="{FF2B5EF4-FFF2-40B4-BE49-F238E27FC236}">
                      <a16:creationId xmlns:a16="http://schemas.microsoft.com/office/drawing/2014/main" id="{C5119FA4-8DE1-46D6-B7AE-19740090900B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4</a:t>
                  </a:r>
                  <a:endParaRPr lang="en-CA" sz="850" baseline="30000" dirty="0"/>
                </a:p>
              </p:txBody>
            </p:sp>
          </p:grpSp>
          <p:grpSp>
            <p:nvGrpSpPr>
              <p:cNvPr id="219" name="Group 218">
                <a:extLst>
                  <a:ext uri="{FF2B5EF4-FFF2-40B4-BE49-F238E27FC236}">
                    <a16:creationId xmlns:a16="http://schemas.microsoft.com/office/drawing/2014/main" id="{0DF315A5-27F7-4219-AA97-A9FC1CECE04E}"/>
                  </a:ext>
                </a:extLst>
              </p:cNvPr>
              <p:cNvGrpSpPr/>
              <p:nvPr/>
            </p:nvGrpSpPr>
            <p:grpSpPr>
              <a:xfrm>
                <a:off x="2860167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29" name="Straight Connector 228">
                  <a:extLst>
                    <a:ext uri="{FF2B5EF4-FFF2-40B4-BE49-F238E27FC236}">
                      <a16:creationId xmlns:a16="http://schemas.microsoft.com/office/drawing/2014/main" id="{ACA51801-2668-4BC6-AF0B-698B67BF342A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TextBox 229">
                  <a:extLst>
                    <a:ext uri="{FF2B5EF4-FFF2-40B4-BE49-F238E27FC236}">
                      <a16:creationId xmlns:a16="http://schemas.microsoft.com/office/drawing/2014/main" id="{E4C137AC-F844-49F3-8558-75EDF543559B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5</a:t>
                  </a:r>
                  <a:endParaRPr lang="en-CA" sz="850" baseline="30000" dirty="0"/>
                </a:p>
              </p:txBody>
            </p:sp>
          </p:grpSp>
          <p:grpSp>
            <p:nvGrpSpPr>
              <p:cNvPr id="220" name="Group 219">
                <a:extLst>
                  <a:ext uri="{FF2B5EF4-FFF2-40B4-BE49-F238E27FC236}">
                    <a16:creationId xmlns:a16="http://schemas.microsoft.com/office/drawing/2014/main" id="{457684F1-297D-4C18-9238-27828D1A5185}"/>
                  </a:ext>
                </a:extLst>
              </p:cNvPr>
              <p:cNvGrpSpPr/>
              <p:nvPr/>
            </p:nvGrpSpPr>
            <p:grpSpPr>
              <a:xfrm>
                <a:off x="3110445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27" name="Straight Connector 226">
                  <a:extLst>
                    <a:ext uri="{FF2B5EF4-FFF2-40B4-BE49-F238E27FC236}">
                      <a16:creationId xmlns:a16="http://schemas.microsoft.com/office/drawing/2014/main" id="{F799071E-273F-4617-8C57-9EE9BCE1F4F4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8" name="TextBox 227">
                  <a:extLst>
                    <a:ext uri="{FF2B5EF4-FFF2-40B4-BE49-F238E27FC236}">
                      <a16:creationId xmlns:a16="http://schemas.microsoft.com/office/drawing/2014/main" id="{350FED80-93EA-49B3-B2BA-1007BEAA042D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6</a:t>
                  </a:r>
                  <a:endParaRPr lang="en-CA" sz="850" baseline="30000" dirty="0"/>
                </a:p>
              </p:txBody>
            </p:sp>
          </p:grpSp>
          <p:grpSp>
            <p:nvGrpSpPr>
              <p:cNvPr id="221" name="Group 220">
                <a:extLst>
                  <a:ext uri="{FF2B5EF4-FFF2-40B4-BE49-F238E27FC236}">
                    <a16:creationId xmlns:a16="http://schemas.microsoft.com/office/drawing/2014/main" id="{BC13FD9B-A4A8-4E56-A403-315816585F07}"/>
                  </a:ext>
                </a:extLst>
              </p:cNvPr>
              <p:cNvGrpSpPr/>
              <p:nvPr/>
            </p:nvGrpSpPr>
            <p:grpSpPr>
              <a:xfrm>
                <a:off x="3367227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25" name="Straight Connector 224">
                  <a:extLst>
                    <a:ext uri="{FF2B5EF4-FFF2-40B4-BE49-F238E27FC236}">
                      <a16:creationId xmlns:a16="http://schemas.microsoft.com/office/drawing/2014/main" id="{D1961A29-4DE2-40AF-95DC-294B0D6238A6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6" name="TextBox 225">
                  <a:extLst>
                    <a:ext uri="{FF2B5EF4-FFF2-40B4-BE49-F238E27FC236}">
                      <a16:creationId xmlns:a16="http://schemas.microsoft.com/office/drawing/2014/main" id="{B5E26211-D98E-403F-AF71-89578C2E1145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7</a:t>
                  </a:r>
                  <a:endParaRPr lang="en-CA" sz="850" baseline="30000" dirty="0"/>
                </a:p>
              </p:txBody>
            </p:sp>
          </p:grpSp>
          <p:grpSp>
            <p:nvGrpSpPr>
              <p:cNvPr id="222" name="Group 221">
                <a:extLst>
                  <a:ext uri="{FF2B5EF4-FFF2-40B4-BE49-F238E27FC236}">
                    <a16:creationId xmlns:a16="http://schemas.microsoft.com/office/drawing/2014/main" id="{23427BAC-F3CA-4518-85F8-40766A61D94E}"/>
                  </a:ext>
                </a:extLst>
              </p:cNvPr>
              <p:cNvGrpSpPr/>
              <p:nvPr/>
            </p:nvGrpSpPr>
            <p:grpSpPr>
              <a:xfrm>
                <a:off x="3614038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23" name="Straight Connector 222">
                  <a:extLst>
                    <a:ext uri="{FF2B5EF4-FFF2-40B4-BE49-F238E27FC236}">
                      <a16:creationId xmlns:a16="http://schemas.microsoft.com/office/drawing/2014/main" id="{3B8AA4EF-E527-4B4E-8655-E2ED4DB93A52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4" name="TextBox 223">
                  <a:extLst>
                    <a:ext uri="{FF2B5EF4-FFF2-40B4-BE49-F238E27FC236}">
                      <a16:creationId xmlns:a16="http://schemas.microsoft.com/office/drawing/2014/main" id="{4D2EF463-6C56-4AF7-AD94-4C9A6E3A246D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8</a:t>
                  </a:r>
                  <a:endParaRPr lang="en-CA" sz="850" baseline="30000" dirty="0"/>
                </a:p>
              </p:txBody>
            </p:sp>
          </p:grpSp>
          <p:grpSp>
            <p:nvGrpSpPr>
              <p:cNvPr id="239" name="Group 238">
                <a:extLst>
                  <a:ext uri="{FF2B5EF4-FFF2-40B4-BE49-F238E27FC236}">
                    <a16:creationId xmlns:a16="http://schemas.microsoft.com/office/drawing/2014/main" id="{60ACE302-503C-4E84-AFDC-64F4D5B6D243}"/>
                  </a:ext>
                </a:extLst>
              </p:cNvPr>
              <p:cNvGrpSpPr/>
              <p:nvPr/>
            </p:nvGrpSpPr>
            <p:grpSpPr>
              <a:xfrm>
                <a:off x="1606716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40" name="Straight Connector 239">
                  <a:extLst>
                    <a:ext uri="{FF2B5EF4-FFF2-40B4-BE49-F238E27FC236}">
                      <a16:creationId xmlns:a16="http://schemas.microsoft.com/office/drawing/2014/main" id="{62E83276-0927-44AF-ACA7-B0617CF17B52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74E5F702-5A91-426C-A7F2-A6ADB4D1A911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0</a:t>
                  </a:r>
                  <a:endParaRPr lang="en-CA" sz="850" baseline="30000" dirty="0"/>
                </a:p>
              </p:txBody>
            </p:sp>
          </p:grpSp>
          <p:grpSp>
            <p:nvGrpSpPr>
              <p:cNvPr id="242" name="Group 241">
                <a:extLst>
                  <a:ext uri="{FF2B5EF4-FFF2-40B4-BE49-F238E27FC236}">
                    <a16:creationId xmlns:a16="http://schemas.microsoft.com/office/drawing/2014/main" id="{9445CE2B-419E-4EF4-85AA-F46BD14AF10C}"/>
                  </a:ext>
                </a:extLst>
              </p:cNvPr>
              <p:cNvGrpSpPr/>
              <p:nvPr/>
            </p:nvGrpSpPr>
            <p:grpSpPr>
              <a:xfrm>
                <a:off x="3868038" y="4881044"/>
                <a:ext cx="288032" cy="262514"/>
                <a:chOff x="1305787" y="1764818"/>
                <a:chExt cx="288032" cy="262514"/>
              </a:xfrm>
            </p:grpSpPr>
            <p:cxnSp>
              <p:nvCxnSpPr>
                <p:cNvPr id="243" name="Straight Connector 242">
                  <a:extLst>
                    <a:ext uri="{FF2B5EF4-FFF2-40B4-BE49-F238E27FC236}">
                      <a16:creationId xmlns:a16="http://schemas.microsoft.com/office/drawing/2014/main" id="{D69A1CBE-FD24-4557-AA07-974511207C24}"/>
                    </a:ext>
                  </a:extLst>
                </p:cNvPr>
                <p:cNvCxnSpPr/>
                <p:nvPr/>
              </p:nvCxnSpPr>
              <p:spPr>
                <a:xfrm rot="5400000">
                  <a:off x="1432091" y="1791969"/>
                  <a:ext cx="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4" name="TextBox 243">
                  <a:extLst>
                    <a:ext uri="{FF2B5EF4-FFF2-40B4-BE49-F238E27FC236}">
                      <a16:creationId xmlns:a16="http://schemas.microsoft.com/office/drawing/2014/main" id="{BE5CFB48-DD98-42C7-8A42-50FD3BC538EE}"/>
                    </a:ext>
                  </a:extLst>
                </p:cNvPr>
                <p:cNvSpPr txBox="1"/>
                <p:nvPr/>
              </p:nvSpPr>
              <p:spPr>
                <a:xfrm>
                  <a:off x="1305787" y="1764818"/>
                  <a:ext cx="288032" cy="2625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CA" sz="850" dirty="0"/>
                    <a:t>9</a:t>
                  </a:r>
                  <a:endParaRPr lang="en-CA" sz="850" baseline="30000" dirty="0"/>
                </a:p>
              </p:txBody>
            </p:sp>
          </p:grpSp>
        </p:grp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6594A55-B9EB-DFF6-FDA4-2D24B7802660}"/>
              </a:ext>
            </a:extLst>
          </p:cNvPr>
          <p:cNvSpPr txBox="1"/>
          <p:nvPr/>
        </p:nvSpPr>
        <p:spPr>
          <a:xfrm>
            <a:off x="4129192" y="3627847"/>
            <a:ext cx="1124994" cy="96565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CA" sz="765" dirty="0"/>
              <a:t>pLSAciHV3-APC-Q1mcp</a:t>
            </a:r>
          </a:p>
        </p:txBody>
      </p:sp>
    </p:spTree>
    <p:extLst>
      <p:ext uri="{BB962C8B-B14F-4D97-AF65-F5344CB8AC3E}">
        <p14:creationId xmlns:p14="http://schemas.microsoft.com/office/powerpoint/2010/main" val="73973414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NGAGE" val="{&quot;SavedSwatch&quot;:&quot;-14272694|-12223080|-16154294|-9539986|-16777216|Fisheries and Oceans Canada&quot;,&quot;Id&quot;:&quot;671696464542452630042e74&quot;,&quot;SmartGridHorizontal&quot;:0,&quot;LinkedExcelSources&quot;:{},&quot;LinkedProjectSources&quot;:{},&quot;FlowConfig&quot;:{&quot;Canvas&quot;:{&quot;Slide&quot;:-1,&quot;Width&quot;:0,&quot;Height&quot;:0},&quot;Timeline&quot;:{&quot;Actions&quot;:[]}},&quot;LinkedSlideMergeSources&quot;:{},&quot;LinkedSharePointSlideMergeSources&quot;:{}}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43</TotalTime>
  <Words>464</Words>
  <Application>Microsoft Office PowerPoint</Application>
  <PresentationFormat>Custom</PresentationFormat>
  <Paragraphs>8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MinionPro-Bold</vt:lpstr>
      <vt:lpstr>MinionPro-Regular</vt:lpstr>
      <vt:lpstr>Palatino Linotype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outhier, Sharon (DFO/MPO)</dc:creator>
  <cp:lastModifiedBy>Clouthier, Sharon (DFO/MPO)</cp:lastModifiedBy>
  <cp:revision>15</cp:revision>
  <dcterms:created xsi:type="dcterms:W3CDTF">2024-09-21T19:33:32Z</dcterms:created>
  <dcterms:modified xsi:type="dcterms:W3CDTF">2025-02-27T20:59:16Z</dcterms:modified>
</cp:coreProperties>
</file>